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  <Override PartName="/ppt/authors.xml" ContentType="application/vnd.ms-powerpoint.author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0"/>
  </p:notesMasterIdLst>
  <p:sldIdLst>
    <p:sldId id="266" r:id="rId5"/>
    <p:sldId id="259" r:id="rId6"/>
    <p:sldId id="261" r:id="rId7"/>
    <p:sldId id="264" r:id="rId8"/>
    <p:sldId id="26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E201E16-5C89-64CE-2FEC-698B97E5EA74}" name="Krithi Pushpanathan" initials="KP" userId="S::krithi.p@nus.edu.sg::8a4bab6f-fbc4-4b0a-a467-7750b395f3d1" providerId="AD"/>
  <p188:author id="{BC476BB0-5B1F-7E17-0CBA-EC6D5E6B0B4A}" name="Soh Zhi Da (Su Zhida)" initials="ZS" userId="S::e0178065@u.nus.edu::3a6628f5-debc-47f4-8b55-dbea9f798b9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771F"/>
    <a:srgbClr val="F65D1F"/>
    <a:srgbClr val="FDC97A"/>
    <a:srgbClr val="FFAF8B"/>
    <a:srgbClr val="FABD61"/>
    <a:srgbClr val="C64409"/>
    <a:srgbClr val="FD9430"/>
    <a:srgbClr val="D9D9D9"/>
    <a:srgbClr val="FFCEA4"/>
    <a:srgbClr val="F0F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01E340-29C7-4C9D-9848-6545CE669FA7}" v="1" dt="2025-04-10T09:10:27.3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rithi Pushpanathan" userId="8a4bab6f-fbc4-4b0a-a467-7750b395f3d1" providerId="ADAL" clId="{4C1335E6-BCB4-4777-A5FB-14C545CF23D6}"/>
    <pc:docChg chg="delSld modSld delSection modSection">
      <pc:chgData name="Krithi Pushpanathan" userId="8a4bab6f-fbc4-4b0a-a467-7750b395f3d1" providerId="ADAL" clId="{4C1335E6-BCB4-4777-A5FB-14C545CF23D6}" dt="2025-04-07T06:48:16.829" v="16" actId="47"/>
      <pc:docMkLst>
        <pc:docMk/>
      </pc:docMkLst>
      <pc:sldChg chg="modSp del mod">
        <pc:chgData name="Krithi Pushpanathan" userId="8a4bab6f-fbc4-4b0a-a467-7750b395f3d1" providerId="ADAL" clId="{4C1335E6-BCB4-4777-A5FB-14C545CF23D6}" dt="2025-04-07T06:47:23.223" v="14" actId="18676"/>
        <pc:sldMkLst>
          <pc:docMk/>
          <pc:sldMk cId="2785487486" sldId="256"/>
        </pc:sldMkLst>
      </pc:sldChg>
      <pc:sldChg chg="modSp del">
        <pc:chgData name="Krithi Pushpanathan" userId="8a4bab6f-fbc4-4b0a-a467-7750b395f3d1" providerId="ADAL" clId="{4C1335E6-BCB4-4777-A5FB-14C545CF23D6}" dt="2025-04-07T06:47:23.223" v="14" actId="18676"/>
        <pc:sldMkLst>
          <pc:docMk/>
          <pc:sldMk cId="4179880080" sldId="257"/>
        </pc:sldMkLst>
      </pc:sldChg>
      <pc:sldChg chg="modSp del mod">
        <pc:chgData name="Krithi Pushpanathan" userId="8a4bab6f-fbc4-4b0a-a467-7750b395f3d1" providerId="ADAL" clId="{4C1335E6-BCB4-4777-A5FB-14C545CF23D6}" dt="2025-04-07T06:47:23.223" v="14" actId="18676"/>
        <pc:sldMkLst>
          <pc:docMk/>
          <pc:sldMk cId="1368078184" sldId="258"/>
        </pc:sldMkLst>
      </pc:sldChg>
      <pc:sldChg chg="del">
        <pc:chgData name="Krithi Pushpanathan" userId="8a4bab6f-fbc4-4b0a-a467-7750b395f3d1" providerId="ADAL" clId="{4C1335E6-BCB4-4777-A5FB-14C545CF23D6}" dt="2025-04-07T06:48:16.829" v="16" actId="47"/>
        <pc:sldMkLst>
          <pc:docMk/>
          <pc:sldMk cId="2607023174" sldId="259"/>
        </pc:sldMkLst>
      </pc:sldChg>
      <pc:sldChg chg="modSp del mod">
        <pc:chgData name="Krithi Pushpanathan" userId="8a4bab6f-fbc4-4b0a-a467-7750b395f3d1" providerId="ADAL" clId="{4C1335E6-BCB4-4777-A5FB-14C545CF23D6}" dt="2025-04-07T06:47:23.223" v="14" actId="18676"/>
        <pc:sldMkLst>
          <pc:docMk/>
          <pc:sldMk cId="4154669207" sldId="260"/>
        </pc:sldMkLst>
      </pc:sldChg>
    </pc:docChg>
  </pc:docChgLst>
  <pc:docChgLst>
    <pc:chgData name="Krithi Pushpanathan" userId="8a4bab6f-fbc4-4b0a-a467-7750b395f3d1" providerId="ADAL" clId="{3EED1B96-F88A-4CC4-BEB1-CA6135F3264B}"/>
    <pc:docChg chg="undo redo custSel modSld sldOrd modSection">
      <pc:chgData name="Krithi Pushpanathan" userId="8a4bab6f-fbc4-4b0a-a467-7750b395f3d1" providerId="ADAL" clId="{3EED1B96-F88A-4CC4-BEB1-CA6135F3264B}" dt="2025-02-21T03:59:51.644" v="1109" actId="20577"/>
      <pc:docMkLst>
        <pc:docMk/>
      </pc:docMkLst>
      <pc:sldChg chg="addSp delSp modSp mod">
        <pc:chgData name="Krithi Pushpanathan" userId="8a4bab6f-fbc4-4b0a-a467-7750b395f3d1" providerId="ADAL" clId="{3EED1B96-F88A-4CC4-BEB1-CA6135F3264B}" dt="2025-02-21T03:59:01.898" v="1091" actId="20577"/>
        <pc:sldMkLst>
          <pc:docMk/>
          <pc:sldMk cId="2785487486" sldId="256"/>
        </pc:sldMkLst>
      </pc:sldChg>
      <pc:sldChg chg="addSp delSp modSp mod">
        <pc:chgData name="Krithi Pushpanathan" userId="8a4bab6f-fbc4-4b0a-a467-7750b395f3d1" providerId="ADAL" clId="{3EED1B96-F88A-4CC4-BEB1-CA6135F3264B}" dt="2025-02-21T03:59:06.069" v="1092" actId="20577"/>
        <pc:sldMkLst>
          <pc:docMk/>
          <pc:sldMk cId="4179880080" sldId="257"/>
        </pc:sldMkLst>
      </pc:sldChg>
      <pc:sldChg chg="addSp delSp modSp mod">
        <pc:chgData name="Krithi Pushpanathan" userId="8a4bab6f-fbc4-4b0a-a467-7750b395f3d1" providerId="ADAL" clId="{3EED1B96-F88A-4CC4-BEB1-CA6135F3264B}" dt="2025-02-21T03:59:12.388" v="1093" actId="20577"/>
        <pc:sldMkLst>
          <pc:docMk/>
          <pc:sldMk cId="1368078184" sldId="258"/>
        </pc:sldMkLst>
      </pc:sldChg>
      <pc:sldChg chg="modSp mod ord">
        <pc:chgData name="Krithi Pushpanathan" userId="8a4bab6f-fbc4-4b0a-a467-7750b395f3d1" providerId="ADAL" clId="{3EED1B96-F88A-4CC4-BEB1-CA6135F3264B}" dt="2025-02-21T03:59:22.964" v="1104" actId="20577"/>
        <pc:sldMkLst>
          <pc:docMk/>
          <pc:sldMk cId="2607023174" sldId="259"/>
        </pc:sldMkLst>
        <pc:spChg chg="mod">
          <ac:chgData name="Krithi Pushpanathan" userId="8a4bab6f-fbc4-4b0a-a467-7750b395f3d1" providerId="ADAL" clId="{3EED1B96-F88A-4CC4-BEB1-CA6135F3264B}" dt="2025-02-21T03:59:22.964" v="1104" actId="20577"/>
          <ac:spMkLst>
            <pc:docMk/>
            <pc:sldMk cId="2607023174" sldId="259"/>
            <ac:spMk id="2" creationId="{2A9D3248-2F17-BEAB-EEEA-BA0C0B097243}"/>
          </ac:spMkLst>
        </pc:spChg>
      </pc:sldChg>
      <pc:sldChg chg="addSp delSp modSp mod">
        <pc:chgData name="Krithi Pushpanathan" userId="8a4bab6f-fbc4-4b0a-a467-7750b395f3d1" providerId="ADAL" clId="{3EED1B96-F88A-4CC4-BEB1-CA6135F3264B}" dt="2025-02-21T03:59:14.675" v="1094" actId="20577"/>
        <pc:sldMkLst>
          <pc:docMk/>
          <pc:sldMk cId="4154669207" sldId="260"/>
        </pc:sldMkLst>
      </pc:sldChg>
      <pc:sldChg chg="modSp mod modCm">
        <pc:chgData name="Krithi Pushpanathan" userId="8a4bab6f-fbc4-4b0a-a467-7750b395f3d1" providerId="ADAL" clId="{3EED1B96-F88A-4CC4-BEB1-CA6135F3264B}" dt="2025-02-21T03:59:42.073" v="1107" actId="122"/>
        <pc:sldMkLst>
          <pc:docMk/>
          <pc:sldMk cId="2199301547" sldId="261"/>
        </pc:sldMkLst>
        <pc:spChg chg="mod">
          <ac:chgData name="Krithi Pushpanathan" userId="8a4bab6f-fbc4-4b0a-a467-7750b395f3d1" providerId="ADAL" clId="{3EED1B96-F88A-4CC4-BEB1-CA6135F3264B}" dt="2025-02-21T03:59:42.073" v="1107" actId="122"/>
          <ac:spMkLst>
            <pc:docMk/>
            <pc:sldMk cId="2199301547" sldId="261"/>
            <ac:spMk id="2" creationId="{2A9D3248-2F17-BEAB-EEEA-BA0C0B097243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mod">
              <pc226:chgData name="Krithi Pushpanathan" userId="8a4bab6f-fbc4-4b0a-a467-7750b395f3d1" providerId="ADAL" clId="{3EED1B96-F88A-4CC4-BEB1-CA6135F3264B}" dt="2025-02-10T08:58:24.369" v="1062" actId="20577"/>
              <pc2:cmMkLst xmlns:pc2="http://schemas.microsoft.com/office/powerpoint/2019/9/main/command">
                <pc:docMk/>
                <pc:sldMk cId="2199301547" sldId="261"/>
                <pc2:cmMk id="{06AC4945-0138-45D3-A767-7D914D133A87}"/>
              </pc2:cmMkLst>
            </pc226:cmChg>
          </p:ext>
        </pc:extLst>
      </pc:sldChg>
      <pc:sldChg chg="modSp mod">
        <pc:chgData name="Krithi Pushpanathan" userId="8a4bab6f-fbc4-4b0a-a467-7750b395f3d1" providerId="ADAL" clId="{3EED1B96-F88A-4CC4-BEB1-CA6135F3264B}" dt="2025-02-21T03:59:48.208" v="1108" actId="20577"/>
        <pc:sldMkLst>
          <pc:docMk/>
          <pc:sldMk cId="1124651727" sldId="264"/>
        </pc:sldMkLst>
        <pc:spChg chg="mod">
          <ac:chgData name="Krithi Pushpanathan" userId="8a4bab6f-fbc4-4b0a-a467-7750b395f3d1" providerId="ADAL" clId="{3EED1B96-F88A-4CC4-BEB1-CA6135F3264B}" dt="2025-02-21T03:59:48.208" v="1108" actId="20577"/>
          <ac:spMkLst>
            <pc:docMk/>
            <pc:sldMk cId="1124651727" sldId="264"/>
            <ac:spMk id="2" creationId="{2A9D3248-2F17-BEAB-EEEA-BA0C0B097243}"/>
          </ac:spMkLst>
        </pc:spChg>
      </pc:sldChg>
      <pc:sldChg chg="addSp delSp modSp mod">
        <pc:chgData name="Krithi Pushpanathan" userId="8a4bab6f-fbc4-4b0a-a467-7750b395f3d1" providerId="ADAL" clId="{3EED1B96-F88A-4CC4-BEB1-CA6135F3264B}" dt="2025-02-21T03:59:51.644" v="1109" actId="20577"/>
        <pc:sldMkLst>
          <pc:docMk/>
          <pc:sldMk cId="2379826258" sldId="265"/>
        </pc:sldMkLst>
        <pc:spChg chg="mod">
          <ac:chgData name="Krithi Pushpanathan" userId="8a4bab6f-fbc4-4b0a-a467-7750b395f3d1" providerId="ADAL" clId="{3EED1B96-F88A-4CC4-BEB1-CA6135F3264B}" dt="2025-02-21T03:59:51.644" v="1109" actId="20577"/>
          <ac:spMkLst>
            <pc:docMk/>
            <pc:sldMk cId="2379826258" sldId="265"/>
            <ac:spMk id="2" creationId="{2A9D3248-2F17-BEAB-EEEA-BA0C0B097243}"/>
          </ac:spMkLst>
        </pc:spChg>
      </pc:sldChg>
      <pc:sldChg chg="modSp mod">
        <pc:chgData name="Krithi Pushpanathan" userId="8a4bab6f-fbc4-4b0a-a467-7750b395f3d1" providerId="ADAL" clId="{3EED1B96-F88A-4CC4-BEB1-CA6135F3264B}" dt="2025-02-10T08:53:37.260" v="992" actId="20577"/>
        <pc:sldMkLst>
          <pc:docMk/>
          <pc:sldMk cId="128401355" sldId="266"/>
        </pc:sldMkLst>
        <pc:spChg chg="mod">
          <ac:chgData name="Krithi Pushpanathan" userId="8a4bab6f-fbc4-4b0a-a467-7750b395f3d1" providerId="ADAL" clId="{3EED1B96-F88A-4CC4-BEB1-CA6135F3264B}" dt="2025-02-10T08:53:37.260" v="992" actId="20577"/>
          <ac:spMkLst>
            <pc:docMk/>
            <pc:sldMk cId="128401355" sldId="266"/>
            <ac:spMk id="15" creationId="{09B91AEE-17D3-E8E8-A9E4-9F528E4A51A1}"/>
          </ac:spMkLst>
        </pc:spChg>
      </pc:sldChg>
    </pc:docChg>
  </pc:docChgLst>
  <pc:docChgLst>
    <pc:chgData name="Krithi Pushpanathan" userId="8a4bab6f-fbc4-4b0a-a467-7750b395f3d1" providerId="ADAL" clId="{759F54F1-DB72-454D-88B2-5D2CB5E2F1F4}"/>
    <pc:docChg chg="modSld">
      <pc:chgData name="Krithi Pushpanathan" userId="8a4bab6f-fbc4-4b0a-a467-7750b395f3d1" providerId="ADAL" clId="{759F54F1-DB72-454D-88B2-5D2CB5E2F1F4}" dt="2025-03-17T03:23:56.629" v="119"/>
      <pc:docMkLst>
        <pc:docMk/>
      </pc:docMkLst>
      <pc:sldChg chg="modSp mod">
        <pc:chgData name="Krithi Pushpanathan" userId="8a4bab6f-fbc4-4b0a-a467-7750b395f3d1" providerId="ADAL" clId="{759F54F1-DB72-454D-88B2-5D2CB5E2F1F4}" dt="2025-03-17T03:23:29.362" v="109" actId="20577"/>
        <pc:sldMkLst>
          <pc:docMk/>
          <pc:sldMk cId="2785487486" sldId="256"/>
        </pc:sldMkLst>
      </pc:sldChg>
      <pc:sldChg chg="modSp mod">
        <pc:chgData name="Krithi Pushpanathan" userId="8a4bab6f-fbc4-4b0a-a467-7750b395f3d1" providerId="ADAL" clId="{759F54F1-DB72-454D-88B2-5D2CB5E2F1F4}" dt="2025-03-17T03:23:56.629" v="119"/>
        <pc:sldMkLst>
          <pc:docMk/>
          <pc:sldMk cId="1368078184" sldId="258"/>
        </pc:sldMkLst>
      </pc:sldChg>
      <pc:sldChg chg="modSp mod">
        <pc:chgData name="Krithi Pushpanathan" userId="8a4bab6f-fbc4-4b0a-a467-7750b395f3d1" providerId="ADAL" clId="{759F54F1-DB72-454D-88B2-5D2CB5E2F1F4}" dt="2025-03-17T03:23:49.908" v="118"/>
        <pc:sldMkLst>
          <pc:docMk/>
          <pc:sldMk cId="4154669207" sldId="260"/>
        </pc:sldMkLst>
      </pc:sldChg>
    </pc:docChg>
  </pc:docChgLst>
  <pc:docChgLst>
    <pc:chgData name="Krithi Pushpanathan" userId="8a4bab6f-fbc4-4b0a-a467-7750b395f3d1" providerId="ADAL" clId="{E01FEFE2-6233-4FE9-9F8C-995FD6846239}"/>
    <pc:docChg chg="undo redo custSel modSld sldOrd">
      <pc:chgData name="Krithi Pushpanathan" userId="8a4bab6f-fbc4-4b0a-a467-7750b395f3d1" providerId="ADAL" clId="{E01FEFE2-6233-4FE9-9F8C-995FD6846239}" dt="2024-12-18T06:37:30.575" v="1312" actId="20577"/>
      <pc:docMkLst>
        <pc:docMk/>
      </pc:docMkLst>
      <pc:sldChg chg="modSp mod">
        <pc:chgData name="Krithi Pushpanathan" userId="8a4bab6f-fbc4-4b0a-a467-7750b395f3d1" providerId="ADAL" clId="{E01FEFE2-6233-4FE9-9F8C-995FD6846239}" dt="2024-12-18T06:35:36.199" v="1279" actId="20577"/>
        <pc:sldMkLst>
          <pc:docMk/>
          <pc:sldMk cId="2785487486" sldId="256"/>
        </pc:sldMkLst>
      </pc:sldChg>
      <pc:sldChg chg="addSp delSp modSp mod modNotesTx">
        <pc:chgData name="Krithi Pushpanathan" userId="8a4bab6f-fbc4-4b0a-a467-7750b395f3d1" providerId="ADAL" clId="{E01FEFE2-6233-4FE9-9F8C-995FD6846239}" dt="2024-12-18T06:37:06.011" v="1307" actId="1076"/>
        <pc:sldMkLst>
          <pc:docMk/>
          <pc:sldMk cId="4179880080" sldId="257"/>
        </pc:sldMkLst>
      </pc:sldChg>
      <pc:sldChg chg="modSp mod">
        <pc:chgData name="Krithi Pushpanathan" userId="8a4bab6f-fbc4-4b0a-a467-7750b395f3d1" providerId="ADAL" clId="{E01FEFE2-6233-4FE9-9F8C-995FD6846239}" dt="2024-12-18T06:35:43.533" v="1280"/>
        <pc:sldMkLst>
          <pc:docMk/>
          <pc:sldMk cId="1368078184" sldId="258"/>
        </pc:sldMkLst>
      </pc:sldChg>
      <pc:sldChg chg="modSp mod">
        <pc:chgData name="Krithi Pushpanathan" userId="8a4bab6f-fbc4-4b0a-a467-7750b395f3d1" providerId="ADAL" clId="{E01FEFE2-6233-4FE9-9F8C-995FD6846239}" dt="2024-12-18T06:35:54.525" v="1290" actId="20577"/>
        <pc:sldMkLst>
          <pc:docMk/>
          <pc:sldMk cId="2607023174" sldId="259"/>
        </pc:sldMkLst>
      </pc:sldChg>
      <pc:sldChg chg="modSp mod">
        <pc:chgData name="Krithi Pushpanathan" userId="8a4bab6f-fbc4-4b0a-a467-7750b395f3d1" providerId="ADAL" clId="{E01FEFE2-6233-4FE9-9F8C-995FD6846239}" dt="2024-12-18T06:35:31.467" v="1267" actId="20577"/>
        <pc:sldMkLst>
          <pc:docMk/>
          <pc:sldMk cId="4154669207" sldId="260"/>
        </pc:sldMkLst>
      </pc:sldChg>
      <pc:sldChg chg="modSp mod">
        <pc:chgData name="Krithi Pushpanathan" userId="8a4bab6f-fbc4-4b0a-a467-7750b395f3d1" providerId="ADAL" clId="{E01FEFE2-6233-4FE9-9F8C-995FD6846239}" dt="2024-12-18T06:37:23.064" v="1309" actId="20577"/>
        <pc:sldMkLst>
          <pc:docMk/>
          <pc:sldMk cId="2199301547" sldId="261"/>
        </pc:sldMkLst>
      </pc:sldChg>
      <pc:sldChg chg="modSp mod">
        <pc:chgData name="Krithi Pushpanathan" userId="8a4bab6f-fbc4-4b0a-a467-7750b395f3d1" providerId="ADAL" clId="{E01FEFE2-6233-4FE9-9F8C-995FD6846239}" dt="2024-12-18T06:37:26.837" v="1310" actId="20577"/>
        <pc:sldMkLst>
          <pc:docMk/>
          <pc:sldMk cId="1124651727" sldId="264"/>
        </pc:sldMkLst>
      </pc:sldChg>
      <pc:sldChg chg="addSp delSp modSp mod">
        <pc:chgData name="Krithi Pushpanathan" userId="8a4bab6f-fbc4-4b0a-a467-7750b395f3d1" providerId="ADAL" clId="{E01FEFE2-6233-4FE9-9F8C-995FD6846239}" dt="2024-12-18T06:37:30.575" v="1312" actId="20577"/>
        <pc:sldMkLst>
          <pc:docMk/>
          <pc:sldMk cId="2379826258" sldId="265"/>
        </pc:sldMkLst>
      </pc:sldChg>
      <pc:sldChg chg="modSp mod ord">
        <pc:chgData name="Krithi Pushpanathan" userId="8a4bab6f-fbc4-4b0a-a467-7750b395f3d1" providerId="ADAL" clId="{E01FEFE2-6233-4FE9-9F8C-995FD6846239}" dt="2024-12-18T06:36:06.801" v="1291" actId="2711"/>
        <pc:sldMkLst>
          <pc:docMk/>
          <pc:sldMk cId="128401355" sldId="266"/>
        </pc:sldMkLst>
      </pc:sldChg>
    </pc:docChg>
  </pc:docChgLst>
  <pc:docChgLst>
    <pc:chgData name="Krithi Pushpanathan" userId="8a4bab6f-fbc4-4b0a-a467-7750b395f3d1" providerId="ADAL" clId="{3F0DCCAA-6976-4AE5-9AAB-E87D10CEB79B}"/>
    <pc:docChg chg="modSld">
      <pc:chgData name="Krithi Pushpanathan" userId="8a4bab6f-fbc4-4b0a-a467-7750b395f3d1" providerId="ADAL" clId="{3F0DCCAA-6976-4AE5-9AAB-E87D10CEB79B}" dt="2024-12-20T04:14:26.700" v="88" actId="20577"/>
      <pc:docMkLst>
        <pc:docMk/>
      </pc:docMkLst>
      <pc:sldChg chg="modSp mod">
        <pc:chgData name="Krithi Pushpanathan" userId="8a4bab6f-fbc4-4b0a-a467-7750b395f3d1" providerId="ADAL" clId="{3F0DCCAA-6976-4AE5-9AAB-E87D10CEB79B}" dt="2024-12-20T04:14:26.700" v="88" actId="20577"/>
        <pc:sldMkLst>
          <pc:docMk/>
          <pc:sldMk cId="4179880080" sldId="257"/>
        </pc:sldMkLst>
      </pc:sldChg>
    </pc:docChg>
  </pc:docChgLst>
  <pc:docChgLst>
    <pc:chgData name="Krithi Pushpanathan" userId="8a4bab6f-fbc4-4b0a-a467-7750b395f3d1" providerId="ADAL" clId="{6901E340-29C7-4C9D-9848-6545CE669FA7}"/>
    <pc:docChg chg="addSld modSld">
      <pc:chgData name="Krithi Pushpanathan" userId="8a4bab6f-fbc4-4b0a-a467-7750b395f3d1" providerId="ADAL" clId="{6901E340-29C7-4C9D-9848-6545CE669FA7}" dt="2025-04-10T09:10:33.080" v="24" actId="20577"/>
      <pc:docMkLst>
        <pc:docMk/>
      </pc:docMkLst>
      <pc:sldChg chg="modSp add mod">
        <pc:chgData name="Krithi Pushpanathan" userId="8a4bab6f-fbc4-4b0a-a467-7750b395f3d1" providerId="ADAL" clId="{6901E340-29C7-4C9D-9848-6545CE669FA7}" dt="2025-04-10T09:10:33.080" v="24" actId="20577"/>
        <pc:sldMkLst>
          <pc:docMk/>
          <pc:sldMk cId="2607023174" sldId="259"/>
        </pc:sldMkLst>
        <pc:spChg chg="mod">
          <ac:chgData name="Krithi Pushpanathan" userId="8a4bab6f-fbc4-4b0a-a467-7750b395f3d1" providerId="ADAL" clId="{6901E340-29C7-4C9D-9848-6545CE669FA7}" dt="2025-04-10T09:10:33.080" v="24" actId="20577"/>
          <ac:spMkLst>
            <pc:docMk/>
            <pc:sldMk cId="2607023174" sldId="259"/>
            <ac:spMk id="2" creationId="{2A9D3248-2F17-BEAB-EEEA-BA0C0B09724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41A02B-CC2F-42EB-AA7B-A51F198E09BB}" type="datetimeFigureOut">
              <a:rPr lang="en-GB" smtClean="0"/>
              <a:t>17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C1B616-6203-46E4-8F48-F2BEDD2149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618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B616-6203-46E4-8F48-F2BEDD21493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4422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B616-6203-46E4-8F48-F2BEDD214938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32184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B616-6203-46E4-8F48-F2BEDD214938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536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B616-6203-46E4-8F48-F2BEDD214938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00837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1B616-6203-46E4-8F48-F2BEDD214938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3085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B54A23-C5A1-87D2-EDC3-73D48255A2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73D936-164E-5EFF-9E03-3135F9717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341176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10992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3.jpeg"/><Relationship Id="rId18" Type="http://schemas.openxmlformats.org/officeDocument/2006/relationships/image" Target="../media/image18.jpeg"/><Relationship Id="rId26" Type="http://schemas.openxmlformats.org/officeDocument/2006/relationships/image" Target="../media/image26.jpeg"/><Relationship Id="rId3" Type="http://schemas.openxmlformats.org/officeDocument/2006/relationships/image" Target="../media/image3.jpeg"/><Relationship Id="rId21" Type="http://schemas.openxmlformats.org/officeDocument/2006/relationships/image" Target="../media/image21.jpeg"/><Relationship Id="rId34" Type="http://schemas.openxmlformats.org/officeDocument/2006/relationships/image" Target="../media/image34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17" Type="http://schemas.openxmlformats.org/officeDocument/2006/relationships/image" Target="../media/image17.jpeg"/><Relationship Id="rId25" Type="http://schemas.openxmlformats.org/officeDocument/2006/relationships/image" Target="../media/image25.jpeg"/><Relationship Id="rId33" Type="http://schemas.openxmlformats.org/officeDocument/2006/relationships/image" Target="../media/image33.jpe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6.jpeg"/><Relationship Id="rId20" Type="http://schemas.openxmlformats.org/officeDocument/2006/relationships/image" Target="../media/image20.jpeg"/><Relationship Id="rId29" Type="http://schemas.openxmlformats.org/officeDocument/2006/relationships/image" Target="../media/image2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24" Type="http://schemas.openxmlformats.org/officeDocument/2006/relationships/image" Target="../media/image24.jpeg"/><Relationship Id="rId32" Type="http://schemas.openxmlformats.org/officeDocument/2006/relationships/image" Target="../media/image32.jpeg"/><Relationship Id="rId5" Type="http://schemas.openxmlformats.org/officeDocument/2006/relationships/image" Target="../media/image5.jpeg"/><Relationship Id="rId15" Type="http://schemas.openxmlformats.org/officeDocument/2006/relationships/image" Target="../media/image15.jpeg"/><Relationship Id="rId23" Type="http://schemas.openxmlformats.org/officeDocument/2006/relationships/image" Target="../media/image23.jpeg"/><Relationship Id="rId28" Type="http://schemas.openxmlformats.org/officeDocument/2006/relationships/image" Target="../media/image28.jpeg"/><Relationship Id="rId10" Type="http://schemas.openxmlformats.org/officeDocument/2006/relationships/image" Target="../media/image10.jpeg"/><Relationship Id="rId19" Type="http://schemas.openxmlformats.org/officeDocument/2006/relationships/image" Target="../media/image19.jpeg"/><Relationship Id="rId31" Type="http://schemas.openxmlformats.org/officeDocument/2006/relationships/image" Target="../media/image31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Relationship Id="rId22" Type="http://schemas.openxmlformats.org/officeDocument/2006/relationships/image" Target="../media/image22.jpeg"/><Relationship Id="rId27" Type="http://schemas.openxmlformats.org/officeDocument/2006/relationships/image" Target="../media/image27.jpeg"/><Relationship Id="rId30" Type="http://schemas.openxmlformats.org/officeDocument/2006/relationships/image" Target="../media/image30.jpeg"/><Relationship Id="rId8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5.jpeg"/><Relationship Id="rId18" Type="http://schemas.openxmlformats.org/officeDocument/2006/relationships/image" Target="../media/image50.jpeg"/><Relationship Id="rId26" Type="http://schemas.openxmlformats.org/officeDocument/2006/relationships/image" Target="../media/image58.jpeg"/><Relationship Id="rId3" Type="http://schemas.openxmlformats.org/officeDocument/2006/relationships/image" Target="../media/image35.jpeg"/><Relationship Id="rId21" Type="http://schemas.openxmlformats.org/officeDocument/2006/relationships/image" Target="../media/image53.jpeg"/><Relationship Id="rId34" Type="http://schemas.openxmlformats.org/officeDocument/2006/relationships/image" Target="../media/image66.jpeg"/><Relationship Id="rId7" Type="http://schemas.openxmlformats.org/officeDocument/2006/relationships/image" Target="../media/image39.jpeg"/><Relationship Id="rId12" Type="http://schemas.openxmlformats.org/officeDocument/2006/relationships/image" Target="../media/image44.jpeg"/><Relationship Id="rId17" Type="http://schemas.openxmlformats.org/officeDocument/2006/relationships/image" Target="../media/image49.jpeg"/><Relationship Id="rId25" Type="http://schemas.openxmlformats.org/officeDocument/2006/relationships/image" Target="../media/image57.jpeg"/><Relationship Id="rId33" Type="http://schemas.openxmlformats.org/officeDocument/2006/relationships/image" Target="../media/image65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48.jpeg"/><Relationship Id="rId20" Type="http://schemas.openxmlformats.org/officeDocument/2006/relationships/image" Target="../media/image52.jpeg"/><Relationship Id="rId29" Type="http://schemas.openxmlformats.org/officeDocument/2006/relationships/image" Target="../media/image6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jpeg"/><Relationship Id="rId11" Type="http://schemas.openxmlformats.org/officeDocument/2006/relationships/image" Target="../media/image43.jpeg"/><Relationship Id="rId24" Type="http://schemas.openxmlformats.org/officeDocument/2006/relationships/image" Target="../media/image56.jpeg"/><Relationship Id="rId32" Type="http://schemas.openxmlformats.org/officeDocument/2006/relationships/image" Target="../media/image64.jpeg"/><Relationship Id="rId5" Type="http://schemas.openxmlformats.org/officeDocument/2006/relationships/image" Target="../media/image37.jpeg"/><Relationship Id="rId15" Type="http://schemas.openxmlformats.org/officeDocument/2006/relationships/image" Target="../media/image47.jpeg"/><Relationship Id="rId23" Type="http://schemas.openxmlformats.org/officeDocument/2006/relationships/image" Target="../media/image55.jpeg"/><Relationship Id="rId28" Type="http://schemas.openxmlformats.org/officeDocument/2006/relationships/image" Target="../media/image60.jpeg"/><Relationship Id="rId10" Type="http://schemas.openxmlformats.org/officeDocument/2006/relationships/image" Target="../media/image42.jpeg"/><Relationship Id="rId19" Type="http://schemas.openxmlformats.org/officeDocument/2006/relationships/image" Target="../media/image51.jpeg"/><Relationship Id="rId31" Type="http://schemas.openxmlformats.org/officeDocument/2006/relationships/image" Target="../media/image63.jpeg"/><Relationship Id="rId4" Type="http://schemas.openxmlformats.org/officeDocument/2006/relationships/image" Target="../media/image36.jpeg"/><Relationship Id="rId9" Type="http://schemas.openxmlformats.org/officeDocument/2006/relationships/image" Target="../media/image41.jpeg"/><Relationship Id="rId14" Type="http://schemas.openxmlformats.org/officeDocument/2006/relationships/image" Target="../media/image46.jpeg"/><Relationship Id="rId22" Type="http://schemas.openxmlformats.org/officeDocument/2006/relationships/image" Target="../media/image54.jpeg"/><Relationship Id="rId27" Type="http://schemas.openxmlformats.org/officeDocument/2006/relationships/image" Target="../media/image59.jpeg"/><Relationship Id="rId30" Type="http://schemas.openxmlformats.org/officeDocument/2006/relationships/image" Target="../media/image62.jpeg"/><Relationship Id="rId8" Type="http://schemas.openxmlformats.org/officeDocument/2006/relationships/image" Target="../media/image40.jpeg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7.jpeg"/><Relationship Id="rId18" Type="http://schemas.openxmlformats.org/officeDocument/2006/relationships/image" Target="../media/image82.jpeg"/><Relationship Id="rId26" Type="http://schemas.openxmlformats.org/officeDocument/2006/relationships/image" Target="../media/image90.jpeg"/><Relationship Id="rId3" Type="http://schemas.openxmlformats.org/officeDocument/2006/relationships/image" Target="../media/image67.jpeg"/><Relationship Id="rId21" Type="http://schemas.openxmlformats.org/officeDocument/2006/relationships/image" Target="../media/image85.jpeg"/><Relationship Id="rId34" Type="http://schemas.openxmlformats.org/officeDocument/2006/relationships/image" Target="../media/image98.jpeg"/><Relationship Id="rId7" Type="http://schemas.openxmlformats.org/officeDocument/2006/relationships/image" Target="../media/image71.jpeg"/><Relationship Id="rId12" Type="http://schemas.openxmlformats.org/officeDocument/2006/relationships/image" Target="../media/image76.jpeg"/><Relationship Id="rId17" Type="http://schemas.openxmlformats.org/officeDocument/2006/relationships/image" Target="../media/image81.jpeg"/><Relationship Id="rId25" Type="http://schemas.openxmlformats.org/officeDocument/2006/relationships/image" Target="../media/image89.jpeg"/><Relationship Id="rId33" Type="http://schemas.openxmlformats.org/officeDocument/2006/relationships/image" Target="../media/image97.jpe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80.jpeg"/><Relationship Id="rId20" Type="http://schemas.openxmlformats.org/officeDocument/2006/relationships/image" Target="../media/image84.jpeg"/><Relationship Id="rId29" Type="http://schemas.openxmlformats.org/officeDocument/2006/relationships/image" Target="../media/image9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0.jpeg"/><Relationship Id="rId11" Type="http://schemas.openxmlformats.org/officeDocument/2006/relationships/image" Target="../media/image75.jpeg"/><Relationship Id="rId24" Type="http://schemas.openxmlformats.org/officeDocument/2006/relationships/image" Target="../media/image88.jpeg"/><Relationship Id="rId32" Type="http://schemas.openxmlformats.org/officeDocument/2006/relationships/image" Target="../media/image96.jpeg"/><Relationship Id="rId5" Type="http://schemas.openxmlformats.org/officeDocument/2006/relationships/image" Target="../media/image69.jpeg"/><Relationship Id="rId15" Type="http://schemas.openxmlformats.org/officeDocument/2006/relationships/image" Target="../media/image79.jpeg"/><Relationship Id="rId23" Type="http://schemas.openxmlformats.org/officeDocument/2006/relationships/image" Target="../media/image87.jpeg"/><Relationship Id="rId28" Type="http://schemas.openxmlformats.org/officeDocument/2006/relationships/image" Target="../media/image92.jpeg"/><Relationship Id="rId10" Type="http://schemas.openxmlformats.org/officeDocument/2006/relationships/image" Target="../media/image74.jpeg"/><Relationship Id="rId19" Type="http://schemas.openxmlformats.org/officeDocument/2006/relationships/image" Target="../media/image83.jpeg"/><Relationship Id="rId31" Type="http://schemas.openxmlformats.org/officeDocument/2006/relationships/image" Target="../media/image95.jpeg"/><Relationship Id="rId4" Type="http://schemas.openxmlformats.org/officeDocument/2006/relationships/image" Target="../media/image68.jpeg"/><Relationship Id="rId9" Type="http://schemas.openxmlformats.org/officeDocument/2006/relationships/image" Target="../media/image73.jpeg"/><Relationship Id="rId14" Type="http://schemas.openxmlformats.org/officeDocument/2006/relationships/image" Target="../media/image78.jpeg"/><Relationship Id="rId22" Type="http://schemas.openxmlformats.org/officeDocument/2006/relationships/image" Target="../media/image86.jpeg"/><Relationship Id="rId27" Type="http://schemas.openxmlformats.org/officeDocument/2006/relationships/image" Target="../media/image91.jpeg"/><Relationship Id="rId30" Type="http://schemas.openxmlformats.org/officeDocument/2006/relationships/image" Target="../media/image94.jpeg"/><Relationship Id="rId8" Type="http://schemas.openxmlformats.org/officeDocument/2006/relationships/image" Target="../media/image7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09B91AEE-17D3-E8E8-A9E4-9F528E4A51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600" y="6062964"/>
            <a:ext cx="11062800" cy="6179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Distribution plots of Systemic Biomarkers a.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 Glycated Haemoglobin (HbA1c, %),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Systolic blood pressure (SBP, mmHg),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Diastolic blood pressure (DBP, mmHg),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in the Training and Internal Test Datasets (SEED + UKBB).</a:t>
            </a:r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0" lang="en-GB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 diagram of blood pressure&#10;&#10;Description automatically generated">
            <a:extLst>
              <a:ext uri="{FF2B5EF4-FFF2-40B4-BE49-F238E27FC236}">
                <a16:creationId xmlns:a16="http://schemas.microsoft.com/office/drawing/2014/main" id="{E605EEE8-99F2-82D3-369A-CCCAD191DA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108" y="64450"/>
            <a:ext cx="10279612" cy="5998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01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A9D3248-2F17-BEAB-EEEA-BA0C0B0972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862" y="5659899"/>
            <a:ext cx="11036273" cy="8891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2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land-Altman </a:t>
            </a:r>
            <a:r>
              <a:rPr lang="en-US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lots Demonstrating the Agreement Between Predicted Values, as Predicted by Vision Transformer</a:t>
            </a:r>
            <a:r>
              <a:rPr lang="en-US" sz="1200" b="1" kern="0" dirty="0">
                <a:latin typeface="Arial" panose="020B0604020202020204" pitchFamily="34" charset="0"/>
                <a:ea typeface="Calibri" panose="020F0502020204030204" pitchFamily="34" charset="0"/>
              </a:rPr>
              <a:t>-Based</a:t>
            </a:r>
            <a:r>
              <a:rPr lang="en-US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odels from Retinal Fundus Images, and Actual Measurements for Systemic Biomarkers </a:t>
            </a:r>
            <a:r>
              <a:rPr lang="en-US" sz="1200" b="1" kern="0" dirty="0"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ross All Test Sets</a:t>
            </a:r>
          </a:p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. </a:t>
            </a:r>
            <a:r>
              <a:rPr lang="en-US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lycated </a:t>
            </a:r>
            <a:r>
              <a:rPr lang="en-US" sz="1200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aemoglobin</a:t>
            </a:r>
            <a:r>
              <a:rPr lang="en-US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HbA1c, %), </a:t>
            </a:r>
            <a:r>
              <a:rPr lang="en-US" sz="1200" b="1" kern="0" dirty="0"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ystolic Blood Pressure (SBP, mmHg)</a:t>
            </a:r>
            <a:r>
              <a:rPr lang="en-US" sz="1200" kern="0" dirty="0">
                <a:latin typeface="Arial" panose="020B0604020202020204" pitchFamily="34" charset="0"/>
                <a:ea typeface="Calibri" panose="020F0502020204030204" pitchFamily="34" charset="0"/>
              </a:rPr>
              <a:t>, and </a:t>
            </a:r>
            <a:r>
              <a:rPr lang="en-US" sz="1200" b="1" kern="0" dirty="0">
                <a:latin typeface="Arial" panose="020B0604020202020204" pitchFamily="34" charset="0"/>
                <a:ea typeface="Calibri" panose="020F0502020204030204" pitchFamily="34" charset="0"/>
              </a:rPr>
              <a:t>c. </a:t>
            </a:r>
            <a:r>
              <a:rPr lang="en-US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iastolic Blood Pressure (DBP, mmHg)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2" name="Picture 11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3C4A2179-0452-16D8-EE2A-DA98668E25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02" b="29698"/>
          <a:stretch/>
        </p:blipFill>
        <p:spPr>
          <a:xfrm>
            <a:off x="-236669" y="964267"/>
            <a:ext cx="12665337" cy="43087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70231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4A1391E5-4440-15D2-A519-AA5FF50489A5}"/>
              </a:ext>
            </a:extLst>
          </p:cNvPr>
          <p:cNvGrpSpPr/>
          <p:nvPr/>
        </p:nvGrpSpPr>
        <p:grpSpPr>
          <a:xfrm>
            <a:off x="0" y="139110"/>
            <a:ext cx="12009305" cy="6500532"/>
            <a:chOff x="0" y="139110"/>
            <a:chExt cx="12009305" cy="6500532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4DC2AF3-A179-29C8-FE84-8E0150631C77}"/>
                </a:ext>
              </a:extLst>
            </p:cNvPr>
            <p:cNvSpPr txBox="1"/>
            <p:nvPr/>
          </p:nvSpPr>
          <p:spPr>
            <a:xfrm>
              <a:off x="0" y="1025944"/>
              <a:ext cx="211122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Healthy</a:t>
              </a:r>
              <a:endParaRPr lang="en-GB" sz="1600"/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403053DD-DCC1-3F67-601E-A1F667E9363D}"/>
                </a:ext>
              </a:extLst>
            </p:cNvPr>
            <p:cNvGrpSpPr/>
            <p:nvPr/>
          </p:nvGrpSpPr>
          <p:grpSpPr>
            <a:xfrm>
              <a:off x="0" y="139110"/>
              <a:ext cx="12009305" cy="6500532"/>
              <a:chOff x="0" y="139110"/>
              <a:chExt cx="12009305" cy="6500532"/>
            </a:xfrm>
          </p:grpSpPr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2A9D3248-2F17-BEAB-EEEA-BA0C0B0972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9081" y="5993311"/>
                <a:ext cx="10113838" cy="6463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just" defTabSz="914400" rtl="0" eaLnBrk="0" fontAlgn="base" latinLnBrk="0" hangingPunct="0">
                  <a:lnSpc>
                    <a:spcPct val="15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b="1" kern="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Supplementary Figure </a:t>
                </a:r>
                <a:r>
                  <a:rPr lang="en-US" sz="1200" b="1" kern="0" dirty="0" smtClea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3: </a:t>
                </a:r>
                <a:r>
                  <a:rPr lang="en-US" sz="1200" b="1" kern="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Saliency Maps Illustrating the </a:t>
                </a:r>
                <a:r>
                  <a:rPr lang="en-US" sz="1200" b="1" kern="0" dirty="0">
                    <a:latin typeface="Arial" panose="020B0604020202020204" pitchFamily="34" charset="0"/>
                    <a:ea typeface="Calibri" panose="020F0502020204030204" pitchFamily="34" charset="0"/>
                  </a:rPr>
                  <a:t>Re</a:t>
                </a:r>
                <a:r>
                  <a:rPr lang="en-US" sz="1200" b="1" kern="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gions of Interest for the Vision Transformer-Based Models in Classifying Diabetes Outcomes</a:t>
                </a:r>
                <a:endPara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81E288D-D578-13BC-D78D-718385C9ADCA}"/>
                  </a:ext>
                </a:extLst>
              </p:cNvPr>
              <p:cNvSpPr txBox="1"/>
              <p:nvPr/>
            </p:nvSpPr>
            <p:spPr>
              <a:xfrm>
                <a:off x="4256527" y="139110"/>
                <a:ext cx="907181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SEED</a:t>
                </a:r>
                <a:endParaRPr lang="en-GB" sz="160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0078FE1-4441-1A5F-E892-75FDE2D254E0}"/>
                  </a:ext>
                </a:extLst>
              </p:cNvPr>
              <p:cNvSpPr txBox="1"/>
              <p:nvPr/>
            </p:nvSpPr>
            <p:spPr>
              <a:xfrm>
                <a:off x="9135684" y="139110"/>
                <a:ext cx="907181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UKBB</a:t>
                </a:r>
                <a:endParaRPr lang="en-GB" sz="160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01A7C22-72A8-FEE5-6C5D-9023DD29D5AB}"/>
                  </a:ext>
                </a:extLst>
              </p:cNvPr>
              <p:cNvSpPr txBox="1"/>
              <p:nvPr/>
            </p:nvSpPr>
            <p:spPr>
              <a:xfrm>
                <a:off x="0" y="2384746"/>
                <a:ext cx="2111223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Pre-Diabetes</a:t>
                </a:r>
                <a:endParaRPr lang="en-GB" sz="160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B7044EF-038F-F4C0-634C-5B41FC5C6FB1}"/>
                  </a:ext>
                </a:extLst>
              </p:cNvPr>
              <p:cNvSpPr txBox="1"/>
              <p:nvPr/>
            </p:nvSpPr>
            <p:spPr>
              <a:xfrm>
                <a:off x="99053" y="3570298"/>
                <a:ext cx="2012170" cy="58477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Well-Controlled </a:t>
                </a:r>
              </a:p>
              <a:p>
                <a:pPr algn="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Diabetes</a:t>
                </a:r>
                <a:endParaRPr lang="en-GB" sz="160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BDC825F-E618-6341-7636-EF21FC0F32CD}"/>
                  </a:ext>
                </a:extLst>
              </p:cNvPr>
              <p:cNvSpPr txBox="1"/>
              <p:nvPr/>
            </p:nvSpPr>
            <p:spPr>
              <a:xfrm>
                <a:off x="65107" y="4859598"/>
                <a:ext cx="2046116" cy="58477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Poorly Controlled </a:t>
                </a:r>
              </a:p>
              <a:p>
                <a:pPr algn="r"/>
                <a:r>
                  <a:rPr lang="en-US" sz="1600" b="1" kern="0"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Diabetes</a:t>
                </a:r>
                <a:endParaRPr lang="en-GB" sz="1600"/>
              </a:p>
            </p:txBody>
          </p:sp>
          <p:sp>
            <p:nvSpPr>
              <p:cNvPr id="11" name="Right Brace 10">
                <a:extLst>
                  <a:ext uri="{FF2B5EF4-FFF2-40B4-BE49-F238E27FC236}">
                    <a16:creationId xmlns:a16="http://schemas.microsoft.com/office/drawing/2014/main" id="{5F8ABFFD-09E4-B128-E6E0-0CC7B5E6FF0E}"/>
                  </a:ext>
                </a:extLst>
              </p:cNvPr>
              <p:cNvSpPr/>
              <p:nvPr/>
            </p:nvSpPr>
            <p:spPr>
              <a:xfrm rot="16200000">
                <a:off x="4595262" y="-1857772"/>
                <a:ext cx="178582" cy="4840062"/>
              </a:xfrm>
              <a:prstGeom prst="rightBrace">
                <a:avLst>
                  <a:gd name="adj1" fmla="val 0"/>
                  <a:gd name="adj2" fmla="val 50000"/>
                </a:avLst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00F28AA0-74D9-153B-99C4-D1FE3627FA60}"/>
                  </a:ext>
                </a:extLst>
              </p:cNvPr>
              <p:cNvGrpSpPr/>
              <p:nvPr/>
            </p:nvGrpSpPr>
            <p:grpSpPr>
              <a:xfrm>
                <a:off x="9694210" y="4588174"/>
                <a:ext cx="2311200" cy="1155600"/>
                <a:chOff x="2290376" y="1540023"/>
                <a:chExt cx="2311200" cy="1155600"/>
              </a:xfrm>
            </p:grpSpPr>
            <p:pic>
              <p:nvPicPr>
                <p:cNvPr id="4" name="Picture 3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64EBB6D3-0C34-EF88-18DD-483AACB3F5C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90376" y="1540023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6" name="Picture 5" descr="A close-up of a circular object&#10;&#10;Description automatically generated">
                  <a:extLst>
                    <a:ext uri="{FF2B5EF4-FFF2-40B4-BE49-F238E27FC236}">
                      <a16:creationId xmlns:a16="http://schemas.microsoft.com/office/drawing/2014/main" id="{DA700610-BCFF-D2C0-6A2B-C384CAE0DD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45976" y="1540023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D47B1AB7-9A44-B021-6186-2CCF7E747162}"/>
                  </a:ext>
                </a:extLst>
              </p:cNvPr>
              <p:cNvGrpSpPr/>
              <p:nvPr/>
            </p:nvGrpSpPr>
            <p:grpSpPr>
              <a:xfrm>
                <a:off x="7235111" y="4588174"/>
                <a:ext cx="2307349" cy="1155600"/>
                <a:chOff x="-1548993" y="-494343"/>
                <a:chExt cx="2307349" cy="1155600"/>
              </a:xfrm>
            </p:grpSpPr>
            <p:pic>
              <p:nvPicPr>
                <p:cNvPr id="8" name="Picture 7" descr="A close-up of a red sphere&#10;&#10;Description automatically generated">
                  <a:extLst>
                    <a:ext uri="{FF2B5EF4-FFF2-40B4-BE49-F238E27FC236}">
                      <a16:creationId xmlns:a16="http://schemas.microsoft.com/office/drawing/2014/main" id="{AAF12A03-7DFB-590F-B399-569879BC440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548993" y="-494343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10" name="Picture 9" descr="A close-up of a planet&#10;&#10;Description automatically generated">
                  <a:extLst>
                    <a:ext uri="{FF2B5EF4-FFF2-40B4-BE49-F238E27FC236}">
                      <a16:creationId xmlns:a16="http://schemas.microsoft.com/office/drawing/2014/main" id="{C484FC75-B4F2-DB80-F44B-A6766C87B1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397244" y="-494343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D3D145B-C0AF-02C6-3897-6778CFA1949D}"/>
                  </a:ext>
                </a:extLst>
              </p:cNvPr>
              <p:cNvGrpSpPr/>
              <p:nvPr/>
            </p:nvGrpSpPr>
            <p:grpSpPr>
              <a:xfrm>
                <a:off x="4763006" y="4587824"/>
                <a:ext cx="2304839" cy="1155950"/>
                <a:chOff x="4763006" y="4587824"/>
                <a:chExt cx="2304839" cy="1155950"/>
              </a:xfrm>
            </p:grpSpPr>
            <p:pic>
              <p:nvPicPr>
                <p:cNvPr id="17" name="Picture 16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5DF4FB54-A6DA-3DE4-7D0F-402BBC21C6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63006" y="4588174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25" name="Picture 24" descr="A close-up of a cell phone screen&#10;&#10;Description automatically generated">
                  <a:extLst>
                    <a:ext uri="{FF2B5EF4-FFF2-40B4-BE49-F238E27FC236}">
                      <a16:creationId xmlns:a16="http://schemas.microsoft.com/office/drawing/2014/main" id="{5D7E0272-DEC7-CDA9-343D-9432BB3A1B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12245" y="4587824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ACE14F23-C6FB-CAA5-712F-326857F820D7}"/>
                  </a:ext>
                </a:extLst>
              </p:cNvPr>
              <p:cNvGrpSpPr/>
              <p:nvPr/>
            </p:nvGrpSpPr>
            <p:grpSpPr>
              <a:xfrm>
                <a:off x="2294806" y="4580768"/>
                <a:ext cx="2307295" cy="1158243"/>
                <a:chOff x="2294806" y="4580768"/>
                <a:chExt cx="2307295" cy="1158243"/>
              </a:xfrm>
            </p:grpSpPr>
            <p:pic>
              <p:nvPicPr>
                <p:cNvPr id="15" name="Picture 14" descr="A screenshot of a scan of a human body&#10;&#10;Description automatically generated">
                  <a:extLst>
                    <a:ext uri="{FF2B5EF4-FFF2-40B4-BE49-F238E27FC236}">
                      <a16:creationId xmlns:a16="http://schemas.microsoft.com/office/drawing/2014/main" id="{9A14EC92-A087-C0E3-1690-D789EDD899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46501" y="4583411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27" name="Picture 26" descr="A close-up of an eye&#10;&#10;Description automatically generated">
                  <a:extLst>
                    <a:ext uri="{FF2B5EF4-FFF2-40B4-BE49-F238E27FC236}">
                      <a16:creationId xmlns:a16="http://schemas.microsoft.com/office/drawing/2014/main" id="{66A9DB5B-05C4-8980-8EA1-847C8A398EA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94806" y="4580768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50FDC7E8-FC50-2BB7-A999-27F5AB6EC665}"/>
                  </a:ext>
                </a:extLst>
              </p:cNvPr>
              <p:cNvGrpSpPr/>
              <p:nvPr/>
            </p:nvGrpSpPr>
            <p:grpSpPr>
              <a:xfrm>
                <a:off x="7235111" y="3286444"/>
                <a:ext cx="2311200" cy="1155601"/>
                <a:chOff x="1448448" y="1201997"/>
                <a:chExt cx="2311200" cy="1155601"/>
              </a:xfrm>
            </p:grpSpPr>
            <p:pic>
              <p:nvPicPr>
                <p:cNvPr id="31" name="Picture 30" descr="A close-up of a round orange object&#10;&#10;Description automatically generated">
                  <a:extLst>
                    <a:ext uri="{FF2B5EF4-FFF2-40B4-BE49-F238E27FC236}">
                      <a16:creationId xmlns:a16="http://schemas.microsoft.com/office/drawing/2014/main" id="{D290EE2C-7E88-990F-0FA3-D3F4E1C324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48448" y="1201998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33" name="Picture 32" descr="A close-up of a planet&#10;&#10;Description automatically generated">
                  <a:extLst>
                    <a:ext uri="{FF2B5EF4-FFF2-40B4-BE49-F238E27FC236}">
                      <a16:creationId xmlns:a16="http://schemas.microsoft.com/office/drawing/2014/main" id="{B37C2878-347E-7407-BA6F-33F05E3A62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04048" y="1201997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F6BC7B95-4DBC-2558-8A12-515C1C364346}"/>
                  </a:ext>
                </a:extLst>
              </p:cNvPr>
              <p:cNvGrpSpPr/>
              <p:nvPr/>
            </p:nvGrpSpPr>
            <p:grpSpPr>
              <a:xfrm>
                <a:off x="9694210" y="3286446"/>
                <a:ext cx="2311200" cy="1155600"/>
                <a:chOff x="7091063" y="1639244"/>
                <a:chExt cx="2311200" cy="1155600"/>
              </a:xfrm>
            </p:grpSpPr>
            <p:pic>
              <p:nvPicPr>
                <p:cNvPr id="35" name="Picture 34" descr="A close-up of a red eyeball&#10;&#10;Description automatically generated">
                  <a:extLst>
                    <a:ext uri="{FF2B5EF4-FFF2-40B4-BE49-F238E27FC236}">
                      <a16:creationId xmlns:a16="http://schemas.microsoft.com/office/drawing/2014/main" id="{74E08377-652D-DECF-7903-0C090DEE8D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91063" y="1639244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37" name="Picture 36" descr="A close-up of a round object&#10;&#10;Description automatically generated">
                  <a:extLst>
                    <a:ext uri="{FF2B5EF4-FFF2-40B4-BE49-F238E27FC236}">
                      <a16:creationId xmlns:a16="http://schemas.microsoft.com/office/drawing/2014/main" id="{5C966C2B-E400-317D-54AB-74EDC41658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246663" y="1639244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C48DCFD4-9996-C4F3-4AA7-F8354D0AF9C3}"/>
                  </a:ext>
                </a:extLst>
              </p:cNvPr>
              <p:cNvGrpSpPr/>
              <p:nvPr/>
            </p:nvGrpSpPr>
            <p:grpSpPr>
              <a:xfrm>
                <a:off x="4763006" y="3286028"/>
                <a:ext cx="2311200" cy="1155775"/>
                <a:chOff x="4763006" y="3286028"/>
                <a:chExt cx="2311200" cy="1155775"/>
              </a:xfrm>
            </p:grpSpPr>
            <p:pic>
              <p:nvPicPr>
                <p:cNvPr id="43" name="Picture 42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9C256D2A-D38A-1384-D218-DE4A627703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63006" y="3286203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45" name="Picture 44" descr="A close-up of a brain scan&#10;&#10;Description automatically generated">
                  <a:extLst>
                    <a:ext uri="{FF2B5EF4-FFF2-40B4-BE49-F238E27FC236}">
                      <a16:creationId xmlns:a16="http://schemas.microsoft.com/office/drawing/2014/main" id="{D727E594-6EAC-A34E-B21C-CCB22D72AE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18606" y="3286028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D4FB7450-3484-8A0A-A2D1-347CD7D55F07}"/>
                  </a:ext>
                </a:extLst>
              </p:cNvPr>
              <p:cNvGrpSpPr/>
              <p:nvPr/>
            </p:nvGrpSpPr>
            <p:grpSpPr>
              <a:xfrm>
                <a:off x="2294806" y="3281265"/>
                <a:ext cx="2307295" cy="1155775"/>
                <a:chOff x="2294806" y="3281265"/>
                <a:chExt cx="2307295" cy="1155775"/>
              </a:xfrm>
            </p:grpSpPr>
            <p:pic>
              <p:nvPicPr>
                <p:cNvPr id="41" name="Picture 40" descr="A close-up of a computer screen&#10;&#10;Description automatically generated">
                  <a:extLst>
                    <a:ext uri="{FF2B5EF4-FFF2-40B4-BE49-F238E27FC236}">
                      <a16:creationId xmlns:a16="http://schemas.microsoft.com/office/drawing/2014/main" id="{A9051A0A-A71F-F07C-76B5-C4E363DD40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46501" y="3281440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47" name="Picture 46" descr="A close-up of a red vein&#10;&#10;Description automatically generated">
                  <a:extLst>
                    <a:ext uri="{FF2B5EF4-FFF2-40B4-BE49-F238E27FC236}">
                      <a16:creationId xmlns:a16="http://schemas.microsoft.com/office/drawing/2014/main" id="{EE577B01-600B-AAD4-A847-687CB43E472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94806" y="3281265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AD018FD3-0D09-E285-31EE-9AF83EE8E95E}"/>
                  </a:ext>
                </a:extLst>
              </p:cNvPr>
              <p:cNvGrpSpPr/>
              <p:nvPr/>
            </p:nvGrpSpPr>
            <p:grpSpPr>
              <a:xfrm>
                <a:off x="7235111" y="1983989"/>
                <a:ext cx="2311200" cy="1156327"/>
                <a:chOff x="4267200" y="1599473"/>
                <a:chExt cx="2311200" cy="1156327"/>
              </a:xfrm>
            </p:grpSpPr>
            <p:pic>
              <p:nvPicPr>
                <p:cNvPr id="51" name="Picture 50" descr="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6A217FFF-1CFF-FF58-3A89-C33BE9C63E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67200" y="1600200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54" name="Picture 53" descr="A close-up of a red circle&#10;&#10;Description automatically generated">
                  <a:extLst>
                    <a:ext uri="{FF2B5EF4-FFF2-40B4-BE49-F238E27FC236}">
                      <a16:creationId xmlns:a16="http://schemas.microsoft.com/office/drawing/2014/main" id="{812A9B91-1257-73BA-9427-A2A9082B83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422800" y="1599473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D3F2CC3A-996E-B730-9DB6-8A9E521B36F5}"/>
                  </a:ext>
                </a:extLst>
              </p:cNvPr>
              <p:cNvGrpSpPr/>
              <p:nvPr/>
            </p:nvGrpSpPr>
            <p:grpSpPr>
              <a:xfrm>
                <a:off x="9694210" y="1983990"/>
                <a:ext cx="2311200" cy="1156327"/>
                <a:chOff x="9016176" y="1599473"/>
                <a:chExt cx="2311200" cy="1156327"/>
              </a:xfrm>
            </p:grpSpPr>
            <p:pic>
              <p:nvPicPr>
                <p:cNvPr id="56" name="Picture 55" descr="A close-up of a red eyeball&#10;&#10;Description automatically generated">
                  <a:extLst>
                    <a:ext uri="{FF2B5EF4-FFF2-40B4-BE49-F238E27FC236}">
                      <a16:creationId xmlns:a16="http://schemas.microsoft.com/office/drawing/2014/main" id="{4045D39B-D988-2F96-8B60-883678BF74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016176" y="1600200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58" name="Picture 57" descr="A close-up of a circular object&#10;&#10;Description automatically generated">
                  <a:extLst>
                    <a:ext uri="{FF2B5EF4-FFF2-40B4-BE49-F238E27FC236}">
                      <a16:creationId xmlns:a16="http://schemas.microsoft.com/office/drawing/2014/main" id="{CF9AF573-DD01-110F-4290-DB9FF41BF4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171776" y="1599473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C571FF9A-EDF5-C5EA-B0E8-85D4279C6C26}"/>
                  </a:ext>
                </a:extLst>
              </p:cNvPr>
              <p:cNvGrpSpPr/>
              <p:nvPr/>
            </p:nvGrpSpPr>
            <p:grpSpPr>
              <a:xfrm>
                <a:off x="2294806" y="1981763"/>
                <a:ext cx="2308465" cy="1155600"/>
                <a:chOff x="456937" y="308387"/>
                <a:chExt cx="2308465" cy="1155600"/>
              </a:xfrm>
            </p:grpSpPr>
            <p:pic>
              <p:nvPicPr>
                <p:cNvPr id="62" name="Picture 61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6B751CA4-1345-62AD-BFC1-0E2DCE3207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6937" y="308387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64" name="Picture 63" descr="A close-up of a scan of an egg&#10;&#10;Description automatically generated">
                  <a:extLst>
                    <a:ext uri="{FF2B5EF4-FFF2-40B4-BE49-F238E27FC236}">
                      <a16:creationId xmlns:a16="http://schemas.microsoft.com/office/drawing/2014/main" id="{607B91E1-91AC-068B-1A77-E25C48F27A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09802" y="308387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414D671D-9EF5-CB7C-CA0E-852CDC027F7F}"/>
                  </a:ext>
                </a:extLst>
              </p:cNvPr>
              <p:cNvGrpSpPr/>
              <p:nvPr/>
            </p:nvGrpSpPr>
            <p:grpSpPr>
              <a:xfrm>
                <a:off x="4763006" y="1984232"/>
                <a:ext cx="2311200" cy="1155600"/>
                <a:chOff x="4845000" y="308387"/>
                <a:chExt cx="2311200" cy="1155600"/>
              </a:xfrm>
            </p:grpSpPr>
            <p:pic>
              <p:nvPicPr>
                <p:cNvPr id="66" name="Picture 65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45C34BFD-F58E-0EE7-A744-B70B4E62FB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45000" y="308387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68" name="Picture 67" descr="A close-up of a scan of a human body&#10;&#10;Description automatically generated">
                  <a:extLst>
                    <a:ext uri="{FF2B5EF4-FFF2-40B4-BE49-F238E27FC236}">
                      <a16:creationId xmlns:a16="http://schemas.microsoft.com/office/drawing/2014/main" id="{1B1565BC-B315-A757-9852-CA9702C385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00600" y="308387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8E7CB527-7162-D0DE-D3F2-BDB95B2C7BCE}"/>
                  </a:ext>
                </a:extLst>
              </p:cNvPr>
              <p:cNvGrpSpPr/>
              <p:nvPr/>
            </p:nvGrpSpPr>
            <p:grpSpPr>
              <a:xfrm>
                <a:off x="7235111" y="682261"/>
                <a:ext cx="2298477" cy="1155600"/>
                <a:chOff x="4284885" y="1600200"/>
                <a:chExt cx="2298477" cy="1155600"/>
              </a:xfrm>
            </p:grpSpPr>
            <p:pic>
              <p:nvPicPr>
                <p:cNvPr id="72" name="Picture 71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7AE07850-2167-4544-5F27-7679E42F79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84885" y="1600200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74" name="Picture 73" descr="A close-up of a circular object&#10;&#10;Description automatically generated">
                  <a:extLst>
                    <a:ext uri="{FF2B5EF4-FFF2-40B4-BE49-F238E27FC236}">
                      <a16:creationId xmlns:a16="http://schemas.microsoft.com/office/drawing/2014/main" id="{4DD4C8C4-C884-9E96-67CD-95D1A91AD8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427762" y="1600200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A6C87638-014B-F272-189A-C1645F413232}"/>
                  </a:ext>
                </a:extLst>
              </p:cNvPr>
              <p:cNvGrpSpPr/>
              <p:nvPr/>
            </p:nvGrpSpPr>
            <p:grpSpPr>
              <a:xfrm>
                <a:off x="9694210" y="682261"/>
                <a:ext cx="2267929" cy="1155600"/>
                <a:chOff x="4267200" y="1600200"/>
                <a:chExt cx="2267929" cy="1155600"/>
              </a:xfrm>
            </p:grpSpPr>
            <p:pic>
              <p:nvPicPr>
                <p:cNvPr id="76" name="Picture 75" descr="A close-up of a red eyeball&#10;&#10;Description automatically generated">
                  <a:extLst>
                    <a:ext uri="{FF2B5EF4-FFF2-40B4-BE49-F238E27FC236}">
                      <a16:creationId xmlns:a16="http://schemas.microsoft.com/office/drawing/2014/main" id="{44B19A3A-E677-F3C7-3C55-CECF949249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67200" y="1600200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78" name="Picture 77" descr="A close-up of a round object&#10;&#10;Description automatically generated">
                  <a:extLst>
                    <a:ext uri="{FF2B5EF4-FFF2-40B4-BE49-F238E27FC236}">
                      <a16:creationId xmlns:a16="http://schemas.microsoft.com/office/drawing/2014/main" id="{3F2A13F2-5F25-131F-5AAB-11BEFF11F9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79529" y="1600200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393B44A0-07B5-651C-A285-0F1B22516A4D}"/>
                  </a:ext>
                </a:extLst>
              </p:cNvPr>
              <p:cNvGrpSpPr/>
              <p:nvPr/>
            </p:nvGrpSpPr>
            <p:grpSpPr>
              <a:xfrm>
                <a:off x="2294806" y="682261"/>
                <a:ext cx="2311200" cy="1155600"/>
                <a:chOff x="2319884" y="709958"/>
                <a:chExt cx="2311200" cy="1155600"/>
              </a:xfrm>
            </p:grpSpPr>
            <p:pic>
              <p:nvPicPr>
                <p:cNvPr id="82" name="Picture 81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3BDF4CD0-E361-7976-8242-5906AE3554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19884" y="709958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84" name="Picture 83" descr="A close-up of a egg&#10;&#10;Description automatically generated">
                  <a:extLst>
                    <a:ext uri="{FF2B5EF4-FFF2-40B4-BE49-F238E27FC236}">
                      <a16:creationId xmlns:a16="http://schemas.microsoft.com/office/drawing/2014/main" id="{5CE9D45C-178C-7EFF-A88E-E2914F5FA8D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75484" y="709958"/>
                  <a:ext cx="1155600" cy="1155600"/>
                </a:xfrm>
                <a:prstGeom prst="rect">
                  <a:avLst/>
                </a:prstGeom>
              </p:spPr>
            </p:pic>
          </p:grpSp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497C3B58-D4A7-5DEE-04E7-CC26B11608AB}"/>
                  </a:ext>
                </a:extLst>
              </p:cNvPr>
              <p:cNvGrpSpPr/>
              <p:nvPr/>
            </p:nvGrpSpPr>
            <p:grpSpPr>
              <a:xfrm>
                <a:off x="4763006" y="682261"/>
                <a:ext cx="2304839" cy="1155600"/>
                <a:chOff x="4763006" y="709958"/>
                <a:chExt cx="2304839" cy="1155600"/>
              </a:xfrm>
            </p:grpSpPr>
            <p:pic>
              <p:nvPicPr>
                <p:cNvPr id="86" name="Picture 85" descr="A close-up of a human eye&#10;&#10;Description automatically generated">
                  <a:extLst>
                    <a:ext uri="{FF2B5EF4-FFF2-40B4-BE49-F238E27FC236}">
                      <a16:creationId xmlns:a16="http://schemas.microsoft.com/office/drawing/2014/main" id="{7C95A2ED-6164-4F96-3817-181E801A15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63006" y="709958"/>
                  <a:ext cx="1155600" cy="1155600"/>
                </a:xfrm>
                <a:prstGeom prst="rect">
                  <a:avLst/>
                </a:prstGeom>
              </p:spPr>
            </p:pic>
            <p:pic>
              <p:nvPicPr>
                <p:cNvPr id="88" name="Picture 87" descr="A close-up of a egg&#10;&#10;Description automatically generated">
                  <a:extLst>
                    <a:ext uri="{FF2B5EF4-FFF2-40B4-BE49-F238E27FC236}">
                      <a16:creationId xmlns:a16="http://schemas.microsoft.com/office/drawing/2014/main" id="{6C21A01F-CADC-64AE-DFF0-BC1B07443A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12245" y="709958"/>
                  <a:ext cx="1155600" cy="1155600"/>
                </a:xfrm>
                <a:prstGeom prst="rect">
                  <a:avLst/>
                </a:prstGeom>
              </p:spPr>
            </p:pic>
          </p:grpSp>
          <p:sp>
            <p:nvSpPr>
              <p:cNvPr id="94" name="Right Brace 93">
                <a:extLst>
                  <a:ext uri="{FF2B5EF4-FFF2-40B4-BE49-F238E27FC236}">
                    <a16:creationId xmlns:a16="http://schemas.microsoft.com/office/drawing/2014/main" id="{3C910456-84FD-1897-99E5-451F6A89911A}"/>
                  </a:ext>
                </a:extLst>
              </p:cNvPr>
              <p:cNvSpPr/>
              <p:nvPr/>
            </p:nvSpPr>
            <p:spPr>
              <a:xfrm rot="16200000">
                <a:off x="9499983" y="-1857773"/>
                <a:ext cx="178582" cy="4840062"/>
              </a:xfrm>
              <a:prstGeom prst="rightBrace">
                <a:avLst>
                  <a:gd name="adj1" fmla="val 0"/>
                  <a:gd name="adj2" fmla="val 50000"/>
                </a:avLst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99301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CBB3FD72-09E4-4CC3-C863-CD5960A40F7F}"/>
              </a:ext>
            </a:extLst>
          </p:cNvPr>
          <p:cNvGrpSpPr/>
          <p:nvPr/>
        </p:nvGrpSpPr>
        <p:grpSpPr>
          <a:xfrm>
            <a:off x="0" y="139110"/>
            <a:ext cx="12009305" cy="6500532"/>
            <a:chOff x="0" y="139110"/>
            <a:chExt cx="12009305" cy="6500532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2A9D3248-2F17-BEAB-EEEA-BA0C0B097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307" y="5993311"/>
              <a:ext cx="10653386" cy="646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just" defTabSz="914400" rtl="0" eaLnBrk="0" fontAlgn="base" latinLnBrk="0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upplementary Figure </a:t>
              </a:r>
              <a:r>
                <a:rPr lang="en-US" sz="1200" b="1" kern="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4: </a:t>
              </a: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aliency Maps Illustrating the </a:t>
              </a:r>
              <a:r>
                <a:rPr lang="en-US" sz="1200" b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Re</a:t>
              </a: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gions of Interest for the Vision Transformer-Based Models in Classifying Hypertension Outcomes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81E288D-D578-13BC-D78D-718385C9ADCA}"/>
                </a:ext>
              </a:extLst>
            </p:cNvPr>
            <p:cNvSpPr txBox="1"/>
            <p:nvPr/>
          </p:nvSpPr>
          <p:spPr>
            <a:xfrm>
              <a:off x="4256527" y="139110"/>
              <a:ext cx="90718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EED</a:t>
              </a:r>
              <a:endParaRPr lang="en-GB" sz="160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0078FE1-4441-1A5F-E892-75FDE2D254E0}"/>
                </a:ext>
              </a:extLst>
            </p:cNvPr>
            <p:cNvSpPr txBox="1"/>
            <p:nvPr/>
          </p:nvSpPr>
          <p:spPr>
            <a:xfrm>
              <a:off x="9135684" y="139110"/>
              <a:ext cx="90718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UKBB</a:t>
              </a:r>
              <a:endParaRPr lang="en-GB" sz="1600"/>
            </a:p>
          </p:txBody>
        </p:sp>
        <p:sp>
          <p:nvSpPr>
            <p:cNvPr id="11" name="Right Brace 10">
              <a:extLst>
                <a:ext uri="{FF2B5EF4-FFF2-40B4-BE49-F238E27FC236}">
                  <a16:creationId xmlns:a16="http://schemas.microsoft.com/office/drawing/2014/main" id="{5F8ABFFD-09E4-B128-E6E0-0CC7B5E6FF0E}"/>
                </a:ext>
              </a:extLst>
            </p:cNvPr>
            <p:cNvSpPr/>
            <p:nvPr/>
          </p:nvSpPr>
          <p:spPr>
            <a:xfrm rot="16200000">
              <a:off x="4595262" y="-1857772"/>
              <a:ext cx="178582" cy="4840062"/>
            </a:xfrm>
            <a:prstGeom prst="rightBrace">
              <a:avLst>
                <a:gd name="adj1" fmla="val 0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4" name="Right Brace 93">
              <a:extLst>
                <a:ext uri="{FF2B5EF4-FFF2-40B4-BE49-F238E27FC236}">
                  <a16:creationId xmlns:a16="http://schemas.microsoft.com/office/drawing/2014/main" id="{3C910456-84FD-1897-99E5-451F6A89911A}"/>
                </a:ext>
              </a:extLst>
            </p:cNvPr>
            <p:cNvSpPr/>
            <p:nvPr/>
          </p:nvSpPr>
          <p:spPr>
            <a:xfrm rot="16200000">
              <a:off x="9499983" y="-1857773"/>
              <a:ext cx="178582" cy="4840062"/>
            </a:xfrm>
            <a:prstGeom prst="rightBrace">
              <a:avLst>
                <a:gd name="adj1" fmla="val 0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DD8D9F9-897F-DC62-4D4F-E130E61102AD}"/>
                </a:ext>
              </a:extLst>
            </p:cNvPr>
            <p:cNvSpPr txBox="1"/>
            <p:nvPr/>
          </p:nvSpPr>
          <p:spPr>
            <a:xfrm>
              <a:off x="0" y="1057258"/>
              <a:ext cx="211122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Healthy</a:t>
              </a:r>
              <a:endParaRPr lang="en-GB" sz="160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9FD1BA1-73C6-971F-B595-D9CF975C38FC}"/>
                </a:ext>
              </a:extLst>
            </p:cNvPr>
            <p:cNvSpPr txBox="1"/>
            <p:nvPr/>
          </p:nvSpPr>
          <p:spPr>
            <a:xfrm>
              <a:off x="0" y="2384746"/>
              <a:ext cx="211122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Pre-Hypertension</a:t>
              </a:r>
              <a:endParaRPr lang="en-GB" sz="160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9C1A64F-78C5-7BF9-E552-3873970F73B2}"/>
                </a:ext>
              </a:extLst>
            </p:cNvPr>
            <p:cNvSpPr txBox="1"/>
            <p:nvPr/>
          </p:nvSpPr>
          <p:spPr>
            <a:xfrm>
              <a:off x="35452" y="3570298"/>
              <a:ext cx="2075771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Well-Controlled </a:t>
              </a:r>
            </a:p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Hypertension</a:t>
              </a:r>
              <a:endParaRPr lang="en-GB" sz="160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30B2D8E-3923-8969-1EB4-FD552B837502}"/>
                </a:ext>
              </a:extLst>
            </p:cNvPr>
            <p:cNvSpPr txBox="1"/>
            <p:nvPr/>
          </p:nvSpPr>
          <p:spPr>
            <a:xfrm>
              <a:off x="65107" y="4859598"/>
              <a:ext cx="2046116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Poorly Controlled </a:t>
              </a:r>
            </a:p>
            <a:p>
              <a:pPr algn="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Hypertension</a:t>
              </a:r>
              <a:endParaRPr lang="en-GB" sz="1600"/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9257E46-4318-8B14-EBB5-0DB8A73A67A9}"/>
                </a:ext>
              </a:extLst>
            </p:cNvPr>
            <p:cNvGrpSpPr/>
            <p:nvPr/>
          </p:nvGrpSpPr>
          <p:grpSpPr>
            <a:xfrm>
              <a:off x="4763006" y="682261"/>
              <a:ext cx="2311200" cy="1155600"/>
              <a:chOff x="4661999" y="991481"/>
              <a:chExt cx="2311200" cy="1155600"/>
            </a:xfrm>
          </p:grpSpPr>
          <p:pic>
            <p:nvPicPr>
              <p:cNvPr id="6" name="Picture 5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7DF4BFB7-A89B-409C-56B1-08846AC1D2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17599" y="99148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0" name="Picture 9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0AE24A80-74F5-4540-754A-36A16C9B5B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61999" y="991481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1E7C750-ABE0-489E-4596-41094FA39002}"/>
                </a:ext>
              </a:extLst>
            </p:cNvPr>
            <p:cNvGrpSpPr/>
            <p:nvPr/>
          </p:nvGrpSpPr>
          <p:grpSpPr>
            <a:xfrm>
              <a:off x="2299652" y="682261"/>
              <a:ext cx="2311200" cy="1155600"/>
              <a:chOff x="1891724" y="3763182"/>
              <a:chExt cx="2311200" cy="1155600"/>
            </a:xfrm>
          </p:grpSpPr>
          <p:pic>
            <p:nvPicPr>
              <p:cNvPr id="13" name="Picture 12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C93A1410-BB9B-EB56-AA38-3C3064071C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7324" y="3763182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5" name="Picture 1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B66123F7-A6BF-E099-062A-44903653A9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1724" y="3763182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5FF18D94-67E8-D186-459F-A0C29AA9997D}"/>
                </a:ext>
              </a:extLst>
            </p:cNvPr>
            <p:cNvGrpSpPr/>
            <p:nvPr/>
          </p:nvGrpSpPr>
          <p:grpSpPr>
            <a:xfrm>
              <a:off x="2292071" y="1972105"/>
              <a:ext cx="2311200" cy="1155600"/>
              <a:chOff x="2299652" y="2107059"/>
              <a:chExt cx="2311200" cy="1155600"/>
            </a:xfrm>
          </p:grpSpPr>
          <p:pic>
            <p:nvPicPr>
              <p:cNvPr id="29" name="Picture 28" descr="A screen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C15EA767-CF02-0493-CE8A-96786C80DC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55252" y="2107059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31" name="Picture 30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31AD6D9B-1044-A015-A15D-F9FB2EBDA5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99652" y="2107059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FCB25188-F212-FD99-016C-64850B8D314E}"/>
                </a:ext>
              </a:extLst>
            </p:cNvPr>
            <p:cNvGrpSpPr/>
            <p:nvPr/>
          </p:nvGrpSpPr>
          <p:grpSpPr>
            <a:xfrm>
              <a:off x="4763006" y="3272782"/>
              <a:ext cx="2311200" cy="1155600"/>
              <a:chOff x="5004483" y="3227500"/>
              <a:chExt cx="2311200" cy="1155600"/>
            </a:xfrm>
          </p:grpSpPr>
          <p:pic>
            <p:nvPicPr>
              <p:cNvPr id="37" name="Picture 36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1324CEB2-3E6B-2160-C0E8-663AD5D842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4483" y="322750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39" name="Picture 38" descr="A close-up of a colorful egg&#10;&#10;Description automatically generated">
                <a:extLst>
                  <a:ext uri="{FF2B5EF4-FFF2-40B4-BE49-F238E27FC236}">
                    <a16:creationId xmlns:a16="http://schemas.microsoft.com/office/drawing/2014/main" id="{891DABA6-8435-32EA-23D3-AB5DA58999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60083" y="322750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71C27598-17AB-AE88-9E5C-06C28F6288FA}"/>
                </a:ext>
              </a:extLst>
            </p:cNvPr>
            <p:cNvGrpSpPr/>
            <p:nvPr/>
          </p:nvGrpSpPr>
          <p:grpSpPr>
            <a:xfrm>
              <a:off x="2305147" y="3269763"/>
              <a:ext cx="2300210" cy="1155600"/>
              <a:chOff x="2305557" y="3328349"/>
              <a:chExt cx="2300210" cy="1155600"/>
            </a:xfrm>
          </p:grpSpPr>
          <p:pic>
            <p:nvPicPr>
              <p:cNvPr id="41" name="Picture 40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4671627E-D97E-B3CB-A378-DA90D9E148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05557" y="3328349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43" name="Picture 42" descr="A close-up of a brain scan&#10;&#10;Description automatically generated">
                <a:extLst>
                  <a:ext uri="{FF2B5EF4-FFF2-40B4-BE49-F238E27FC236}">
                    <a16:creationId xmlns:a16="http://schemas.microsoft.com/office/drawing/2014/main" id="{3919FE31-66E3-BE61-0B2E-1C529F7B21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50167" y="3328349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D5916B34-7CD4-167F-3D56-55CAD188D2F1}"/>
                </a:ext>
              </a:extLst>
            </p:cNvPr>
            <p:cNvGrpSpPr/>
            <p:nvPr/>
          </p:nvGrpSpPr>
          <p:grpSpPr>
            <a:xfrm>
              <a:off x="9681770" y="671853"/>
              <a:ext cx="2303619" cy="1158226"/>
              <a:chOff x="4267200" y="1597574"/>
              <a:chExt cx="2303619" cy="1158226"/>
            </a:xfrm>
          </p:grpSpPr>
          <p:pic>
            <p:nvPicPr>
              <p:cNvPr id="53" name="Picture 52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C79492AF-BBCB-0909-60B5-F6AA724544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7200" y="160020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55" name="Picture 54" descr="A close-up of a planet&#10;&#10;Description automatically generated">
                <a:extLst>
                  <a:ext uri="{FF2B5EF4-FFF2-40B4-BE49-F238E27FC236}">
                    <a16:creationId xmlns:a16="http://schemas.microsoft.com/office/drawing/2014/main" id="{EE85BE00-B58F-0BE2-D2A1-D81530A90F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15219" y="1597574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95E6BE23-97D4-C8D7-250F-42E689DC2191}"/>
                </a:ext>
              </a:extLst>
            </p:cNvPr>
            <p:cNvGrpSpPr/>
            <p:nvPr/>
          </p:nvGrpSpPr>
          <p:grpSpPr>
            <a:xfrm>
              <a:off x="7222388" y="673166"/>
              <a:ext cx="2311200" cy="1155600"/>
              <a:chOff x="3596065" y="-2317891"/>
              <a:chExt cx="2311200" cy="1155600"/>
            </a:xfrm>
          </p:grpSpPr>
          <p:pic>
            <p:nvPicPr>
              <p:cNvPr id="57" name="Picture 56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12E29294-4F10-EA35-6E45-03C52C2659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96065" y="-231789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59" name="Picture 58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5549856A-6866-18D4-2600-A7760F6F33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51665" y="-2317891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93B00FD6-87B1-D20D-6355-B37E247CCEC2}"/>
                </a:ext>
              </a:extLst>
            </p:cNvPr>
            <p:cNvGrpSpPr/>
            <p:nvPr/>
          </p:nvGrpSpPr>
          <p:grpSpPr>
            <a:xfrm>
              <a:off x="9677428" y="1972105"/>
              <a:ext cx="2311200" cy="1155600"/>
              <a:chOff x="9677428" y="1972105"/>
              <a:chExt cx="2311200" cy="1155600"/>
            </a:xfrm>
          </p:grpSpPr>
          <p:pic>
            <p:nvPicPr>
              <p:cNvPr id="71" name="Picture 70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14D358D2-BEFF-D37A-DF98-105AAA5FA1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677428" y="1972105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73" name="Picture 72" descr="A close-up of a round object&#10;&#10;Description automatically generated">
                <a:extLst>
                  <a:ext uri="{FF2B5EF4-FFF2-40B4-BE49-F238E27FC236}">
                    <a16:creationId xmlns:a16="http://schemas.microsoft.com/office/drawing/2014/main" id="{8AA4561A-08FF-704F-EB06-F0FC201D1D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33028" y="1972105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0DE7CCA-5933-DFB1-471C-E11A33C99AA3}"/>
                </a:ext>
              </a:extLst>
            </p:cNvPr>
            <p:cNvGrpSpPr/>
            <p:nvPr/>
          </p:nvGrpSpPr>
          <p:grpSpPr>
            <a:xfrm>
              <a:off x="7235111" y="1972105"/>
              <a:ext cx="2311200" cy="1155600"/>
              <a:chOff x="7235111" y="1972105"/>
              <a:chExt cx="2311200" cy="1155600"/>
            </a:xfrm>
          </p:grpSpPr>
          <p:pic>
            <p:nvPicPr>
              <p:cNvPr id="69" name="Picture 68" descr="A close-up of a round object&#10;&#10;Description automatically generated">
                <a:extLst>
                  <a:ext uri="{FF2B5EF4-FFF2-40B4-BE49-F238E27FC236}">
                    <a16:creationId xmlns:a16="http://schemas.microsoft.com/office/drawing/2014/main" id="{41103070-FC41-1E9F-7E11-73D1D7DCC9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90711" y="1972105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75" name="Picture 74" descr="Close-up of a human eye&#10;&#10;Description automatically generated">
                <a:extLst>
                  <a:ext uri="{FF2B5EF4-FFF2-40B4-BE49-F238E27FC236}">
                    <a16:creationId xmlns:a16="http://schemas.microsoft.com/office/drawing/2014/main" id="{EAA25EE7-9C06-D70F-517D-2835B94B96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35111" y="1972105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1D67043E-3D6E-584F-E419-2F92F44EDA42}"/>
                </a:ext>
              </a:extLst>
            </p:cNvPr>
            <p:cNvGrpSpPr/>
            <p:nvPr/>
          </p:nvGrpSpPr>
          <p:grpSpPr>
            <a:xfrm>
              <a:off x="7235111" y="3277539"/>
              <a:ext cx="2311200" cy="1155600"/>
              <a:chOff x="4267200" y="1600200"/>
              <a:chExt cx="2311200" cy="1155600"/>
            </a:xfrm>
          </p:grpSpPr>
          <p:pic>
            <p:nvPicPr>
              <p:cNvPr id="85" name="Picture 8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5970F7FB-3AB6-460A-047E-CBF8D761C2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7200" y="160020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87" name="Picture 86" descr="A circular object with many dots&#10;&#10;Description automatically generated with medium confidence">
                <a:extLst>
                  <a:ext uri="{FF2B5EF4-FFF2-40B4-BE49-F238E27FC236}">
                    <a16:creationId xmlns:a16="http://schemas.microsoft.com/office/drawing/2014/main" id="{FCEB13BE-E294-A9FC-4DDE-23F69DA634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2800" y="160020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93E19E52-4F93-418C-33BC-8158A65154CB}"/>
                </a:ext>
              </a:extLst>
            </p:cNvPr>
            <p:cNvGrpSpPr/>
            <p:nvPr/>
          </p:nvGrpSpPr>
          <p:grpSpPr>
            <a:xfrm>
              <a:off x="4771473" y="1972105"/>
              <a:ext cx="2303619" cy="1155600"/>
              <a:chOff x="598927" y="1600200"/>
              <a:chExt cx="2303619" cy="1155600"/>
            </a:xfrm>
          </p:grpSpPr>
          <p:pic>
            <p:nvPicPr>
              <p:cNvPr id="91" name="Picture 90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C067E8F2-46CB-7F9F-3E40-4237116BE1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46946" y="160020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93" name="Picture 92" descr="A close-up of a red light&#10;&#10;Description automatically generated">
                <a:extLst>
                  <a:ext uri="{FF2B5EF4-FFF2-40B4-BE49-F238E27FC236}">
                    <a16:creationId xmlns:a16="http://schemas.microsoft.com/office/drawing/2014/main" id="{5C506DBA-5DEA-D2B0-9B5C-35445DC417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8927" y="160020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99673DFC-CB08-91F2-5520-2EF27C489238}"/>
                </a:ext>
              </a:extLst>
            </p:cNvPr>
            <p:cNvGrpSpPr/>
            <p:nvPr/>
          </p:nvGrpSpPr>
          <p:grpSpPr>
            <a:xfrm>
              <a:off x="9677428" y="3269763"/>
              <a:ext cx="2302278" cy="1155600"/>
              <a:chOff x="633152" y="1609680"/>
              <a:chExt cx="2302278" cy="1155600"/>
            </a:xfrm>
          </p:grpSpPr>
          <p:pic>
            <p:nvPicPr>
              <p:cNvPr id="97" name="Picture 96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7AF9F2BF-B16E-DA93-92C0-AFECBFAB83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79830" y="160968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99" name="Picture 98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3B9D1FE1-BF06-F6C8-96FC-4C77EBCACC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3152" y="160968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860FC39-E906-342F-F64D-1FCBD2EF227F}"/>
                </a:ext>
              </a:extLst>
            </p:cNvPr>
            <p:cNvGrpSpPr/>
            <p:nvPr/>
          </p:nvGrpSpPr>
          <p:grpSpPr>
            <a:xfrm>
              <a:off x="9688418" y="4565837"/>
              <a:ext cx="2300210" cy="1155600"/>
              <a:chOff x="9688418" y="4565837"/>
              <a:chExt cx="2300210" cy="1155600"/>
            </a:xfrm>
          </p:grpSpPr>
          <p:pic>
            <p:nvPicPr>
              <p:cNvPr id="104" name="Picture 103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049C441D-92DB-6882-3EB3-55CD864AB2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688418" y="4565837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06" name="Picture 105" descr="A close-up of a planet&#10;&#10;Description automatically generated">
                <a:extLst>
                  <a:ext uri="{FF2B5EF4-FFF2-40B4-BE49-F238E27FC236}">
                    <a16:creationId xmlns:a16="http://schemas.microsoft.com/office/drawing/2014/main" id="{059F9E23-DB39-B4FA-EED1-585DD2B6E5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33028" y="4565837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DF616A3-8484-BC92-C5D5-7F7871813B0F}"/>
                </a:ext>
              </a:extLst>
            </p:cNvPr>
            <p:cNvGrpSpPr/>
            <p:nvPr/>
          </p:nvGrpSpPr>
          <p:grpSpPr>
            <a:xfrm>
              <a:off x="7235111" y="4565837"/>
              <a:ext cx="2311200" cy="1155600"/>
              <a:chOff x="7235111" y="4565837"/>
              <a:chExt cx="2311200" cy="1155600"/>
            </a:xfrm>
          </p:grpSpPr>
          <p:pic>
            <p:nvPicPr>
              <p:cNvPr id="102" name="Picture 101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6060B232-6038-7C06-F450-9110F7B541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90711" y="4565837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08" name="Picture 107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4F04A6F4-B266-43C8-ED30-45A0FF270B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35111" y="4565837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0BD98495-B1C6-593D-93CC-05678C0335DE}"/>
                </a:ext>
              </a:extLst>
            </p:cNvPr>
            <p:cNvGrpSpPr/>
            <p:nvPr/>
          </p:nvGrpSpPr>
          <p:grpSpPr>
            <a:xfrm>
              <a:off x="4763006" y="4556458"/>
              <a:ext cx="2299608" cy="1155600"/>
              <a:chOff x="5024956" y="4635704"/>
              <a:chExt cx="2299608" cy="1155600"/>
            </a:xfrm>
          </p:grpSpPr>
          <p:pic>
            <p:nvPicPr>
              <p:cNvPr id="112" name="Picture 111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EE5A45EC-6EB5-7AA7-9A20-9C5BC59EAC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24956" y="4635704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14" name="Picture 113" descr="A close-up of a computer screen&#10;&#10;Description automatically generated">
                <a:extLst>
                  <a:ext uri="{FF2B5EF4-FFF2-40B4-BE49-F238E27FC236}">
                    <a16:creationId xmlns:a16="http://schemas.microsoft.com/office/drawing/2014/main" id="{AADAF0F9-BD60-AB61-E056-AF43B962AF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68964" y="4635704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7B7B7A66-FE80-5D92-998D-07D83E825171}"/>
                </a:ext>
              </a:extLst>
            </p:cNvPr>
            <p:cNvGrpSpPr/>
            <p:nvPr/>
          </p:nvGrpSpPr>
          <p:grpSpPr>
            <a:xfrm>
              <a:off x="2299652" y="4567421"/>
              <a:ext cx="2311200" cy="1155600"/>
              <a:chOff x="2299652" y="4559607"/>
              <a:chExt cx="2311200" cy="1155600"/>
            </a:xfrm>
          </p:grpSpPr>
          <p:pic>
            <p:nvPicPr>
              <p:cNvPr id="116" name="Picture 115" descr="A close-up of a red light&#10;&#10;Description automatically generated">
                <a:extLst>
                  <a:ext uri="{FF2B5EF4-FFF2-40B4-BE49-F238E27FC236}">
                    <a16:creationId xmlns:a16="http://schemas.microsoft.com/office/drawing/2014/main" id="{65E76B30-7521-026A-639B-E52CBB4AAF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99652" y="4559607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18" name="Picture 117" descr="A close-up of a brain scan&#10;&#10;Description automatically generated">
                <a:extLst>
                  <a:ext uri="{FF2B5EF4-FFF2-40B4-BE49-F238E27FC236}">
                    <a16:creationId xmlns:a16="http://schemas.microsoft.com/office/drawing/2014/main" id="{C476100F-E562-57F3-3A25-C13A58A5A2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55252" y="4559607"/>
                <a:ext cx="1155600" cy="11556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124651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75AD934D-852C-527C-7CE9-374436B209A1}"/>
              </a:ext>
            </a:extLst>
          </p:cNvPr>
          <p:cNvGrpSpPr/>
          <p:nvPr/>
        </p:nvGrpSpPr>
        <p:grpSpPr>
          <a:xfrm>
            <a:off x="694266" y="139110"/>
            <a:ext cx="11315039" cy="6483444"/>
            <a:chOff x="694266" y="139110"/>
            <a:chExt cx="11315039" cy="6483444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2A9D3248-2F17-BEAB-EEEA-BA0C0B097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4266" y="6010399"/>
              <a:ext cx="10727267" cy="612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just" defTabSz="914400" rtl="0" eaLnBrk="0" fontAlgn="base" latinLnBrk="0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upplementary </a:t>
              </a:r>
              <a:r>
                <a:rPr lang="en-US" sz="12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Figure </a:t>
              </a:r>
              <a:r>
                <a:rPr lang="en-US" sz="1200" b="1" kern="0" smtClea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5: </a:t>
              </a: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aliency Maps Illustrating the </a:t>
              </a:r>
              <a:r>
                <a:rPr lang="en-US" sz="1200" b="1" kern="0" dirty="0">
                  <a:latin typeface="Arial" panose="020B0604020202020204" pitchFamily="34" charset="0"/>
                  <a:ea typeface="Calibri" panose="020F0502020204030204" pitchFamily="34" charset="0"/>
                </a:rPr>
                <a:t>Re</a:t>
              </a:r>
              <a:r>
                <a:rPr lang="en-US" sz="1200" b="1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gions of Interest for the Vision Transformer-Based Models in Classifying Hypertension Outcomes among People with Diabetes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81E288D-D578-13BC-D78D-718385C9ADCA}"/>
                </a:ext>
              </a:extLst>
            </p:cNvPr>
            <p:cNvSpPr txBox="1"/>
            <p:nvPr/>
          </p:nvSpPr>
          <p:spPr>
            <a:xfrm>
              <a:off x="4256527" y="139110"/>
              <a:ext cx="90718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EED</a:t>
              </a:r>
              <a:endParaRPr lang="en-GB" sz="160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0078FE1-4441-1A5F-E892-75FDE2D254E0}"/>
                </a:ext>
              </a:extLst>
            </p:cNvPr>
            <p:cNvSpPr txBox="1"/>
            <p:nvPr/>
          </p:nvSpPr>
          <p:spPr>
            <a:xfrm>
              <a:off x="9135684" y="139110"/>
              <a:ext cx="90718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kern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UKBB</a:t>
              </a:r>
              <a:endParaRPr lang="en-GB" sz="1600"/>
            </a:p>
          </p:txBody>
        </p:sp>
        <p:sp>
          <p:nvSpPr>
            <p:cNvPr id="11" name="Right Brace 10">
              <a:extLst>
                <a:ext uri="{FF2B5EF4-FFF2-40B4-BE49-F238E27FC236}">
                  <a16:creationId xmlns:a16="http://schemas.microsoft.com/office/drawing/2014/main" id="{5F8ABFFD-09E4-B128-E6E0-0CC7B5E6FF0E}"/>
                </a:ext>
              </a:extLst>
            </p:cNvPr>
            <p:cNvSpPr/>
            <p:nvPr/>
          </p:nvSpPr>
          <p:spPr>
            <a:xfrm rot="16200000">
              <a:off x="4595262" y="-1857772"/>
              <a:ext cx="178582" cy="4840062"/>
            </a:xfrm>
            <a:prstGeom prst="rightBrace">
              <a:avLst>
                <a:gd name="adj1" fmla="val 0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4" name="Right Brace 93">
              <a:extLst>
                <a:ext uri="{FF2B5EF4-FFF2-40B4-BE49-F238E27FC236}">
                  <a16:creationId xmlns:a16="http://schemas.microsoft.com/office/drawing/2014/main" id="{3C910456-84FD-1897-99E5-451F6A89911A}"/>
                </a:ext>
              </a:extLst>
            </p:cNvPr>
            <p:cNvSpPr/>
            <p:nvPr/>
          </p:nvSpPr>
          <p:spPr>
            <a:xfrm rot="16200000">
              <a:off x="9499983" y="-1857773"/>
              <a:ext cx="178582" cy="4840062"/>
            </a:xfrm>
            <a:prstGeom prst="rightBrace">
              <a:avLst>
                <a:gd name="adj1" fmla="val 0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9C417CDB-07B1-72E8-B253-C66CB279B61C}"/>
                </a:ext>
              </a:extLst>
            </p:cNvPr>
            <p:cNvGrpSpPr/>
            <p:nvPr/>
          </p:nvGrpSpPr>
          <p:grpSpPr>
            <a:xfrm>
              <a:off x="4769751" y="669613"/>
              <a:ext cx="2304455" cy="1155600"/>
              <a:chOff x="2810393" y="2384746"/>
              <a:chExt cx="2304455" cy="1155600"/>
            </a:xfrm>
          </p:grpSpPr>
          <p:pic>
            <p:nvPicPr>
              <p:cNvPr id="10" name="Picture 9" descr="A close-up of a red vein&#10;&#10;Description automatically generated">
                <a:extLst>
                  <a:ext uri="{FF2B5EF4-FFF2-40B4-BE49-F238E27FC236}">
                    <a16:creationId xmlns:a16="http://schemas.microsoft.com/office/drawing/2014/main" id="{E59805F7-8854-E363-0AE7-1316123D0A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10393" y="2384746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3" name="Picture 12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BE605659-0E70-636E-FA84-CA14D035AF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59248" y="2384746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C97FB212-18A3-6CDF-7E2A-B8387B4663D3}"/>
                </a:ext>
              </a:extLst>
            </p:cNvPr>
            <p:cNvGrpSpPr/>
            <p:nvPr/>
          </p:nvGrpSpPr>
          <p:grpSpPr>
            <a:xfrm>
              <a:off x="2299652" y="682261"/>
              <a:ext cx="2311200" cy="1155600"/>
              <a:chOff x="2771059" y="1263905"/>
              <a:chExt cx="2311200" cy="1155600"/>
            </a:xfrm>
          </p:grpSpPr>
          <p:pic>
            <p:nvPicPr>
              <p:cNvPr id="6" name="Picture 5" descr="A close-up of a colorful egg&#10;&#10;Description automatically generated">
                <a:extLst>
                  <a:ext uri="{FF2B5EF4-FFF2-40B4-BE49-F238E27FC236}">
                    <a16:creationId xmlns:a16="http://schemas.microsoft.com/office/drawing/2014/main" id="{1B97BF25-A32F-F366-4E80-236F3F18C7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26659" y="1263905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5" name="Picture 1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444022C0-2C63-20A6-CD4D-4CD72A865A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71059" y="1263905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674F8113-173F-7DD6-B37E-AA925EADDB34}"/>
                </a:ext>
              </a:extLst>
            </p:cNvPr>
            <p:cNvGrpSpPr/>
            <p:nvPr/>
          </p:nvGrpSpPr>
          <p:grpSpPr>
            <a:xfrm>
              <a:off x="7215334" y="676928"/>
              <a:ext cx="2310673" cy="1155600"/>
              <a:chOff x="4213299" y="3762857"/>
              <a:chExt cx="2310673" cy="1155600"/>
            </a:xfrm>
          </p:grpSpPr>
          <p:pic>
            <p:nvPicPr>
              <p:cNvPr id="45" name="Picture 44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B6AA1B7E-59E1-A637-825A-56DC841FB2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13299" y="3762857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46" name="Picture 45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0A7E262F-A64F-50F3-0893-39AED4CDBB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68372" y="3762857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290FEF5F-446C-132C-6B6C-4482D8729F54}"/>
                </a:ext>
              </a:extLst>
            </p:cNvPr>
            <p:cNvGrpSpPr/>
            <p:nvPr/>
          </p:nvGrpSpPr>
          <p:grpSpPr>
            <a:xfrm>
              <a:off x="9674452" y="669227"/>
              <a:ext cx="2310673" cy="1155600"/>
              <a:chOff x="7222915" y="2007840"/>
              <a:chExt cx="2310673" cy="1155600"/>
            </a:xfrm>
          </p:grpSpPr>
          <p:pic>
            <p:nvPicPr>
              <p:cNvPr id="48" name="Picture 47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C99C55FB-A23D-8BFD-C9F1-95310A579D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22915" y="200784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49" name="Picture 48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D2C522B5-7124-6426-CAA1-3B1C841FDF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77988" y="200784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03AE43EF-6D3F-C382-1767-580AD5B543EA}"/>
                </a:ext>
              </a:extLst>
            </p:cNvPr>
            <p:cNvGrpSpPr/>
            <p:nvPr/>
          </p:nvGrpSpPr>
          <p:grpSpPr>
            <a:xfrm>
              <a:off x="2307012" y="1982235"/>
              <a:ext cx="2303840" cy="1155600"/>
              <a:chOff x="598927" y="1670601"/>
              <a:chExt cx="2303840" cy="1155600"/>
            </a:xfrm>
          </p:grpSpPr>
          <p:pic>
            <p:nvPicPr>
              <p:cNvPr id="66" name="Picture 65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62F4DD60-733C-B4C5-7F00-055FF01DB2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47167" y="167060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67" name="Picture 66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A58A40FC-8065-5F84-F908-CEA7D06346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8927" y="1670601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16E6EBDC-3598-2D88-2E76-379D61AF7070}"/>
                </a:ext>
              </a:extLst>
            </p:cNvPr>
            <p:cNvGrpSpPr/>
            <p:nvPr/>
          </p:nvGrpSpPr>
          <p:grpSpPr>
            <a:xfrm>
              <a:off x="4769751" y="1972105"/>
              <a:ext cx="2308572" cy="1155600"/>
              <a:chOff x="4769751" y="3413452"/>
              <a:chExt cx="2308572" cy="1155600"/>
            </a:xfrm>
          </p:grpSpPr>
          <p:pic>
            <p:nvPicPr>
              <p:cNvPr id="70" name="Picture 69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3E8EB78E-21E6-9E0B-D991-E482F65CCC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69751" y="3413452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71" name="Picture 70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044906C2-B7F2-EDE2-44CC-4B3B27F802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22723" y="3413452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C092ABDB-5508-CFBB-6323-BA5678DDFFEF}"/>
                </a:ext>
              </a:extLst>
            </p:cNvPr>
            <p:cNvGrpSpPr/>
            <p:nvPr/>
          </p:nvGrpSpPr>
          <p:grpSpPr>
            <a:xfrm>
              <a:off x="9674452" y="1972105"/>
              <a:ext cx="2311200" cy="1155600"/>
              <a:chOff x="361873" y="2684859"/>
              <a:chExt cx="2311200" cy="1155600"/>
            </a:xfrm>
          </p:grpSpPr>
          <p:pic>
            <p:nvPicPr>
              <p:cNvPr id="73" name="Picture 72" descr="A close-up of a sphere&#10;&#10;Description automatically generated">
                <a:extLst>
                  <a:ext uri="{FF2B5EF4-FFF2-40B4-BE49-F238E27FC236}">
                    <a16:creationId xmlns:a16="http://schemas.microsoft.com/office/drawing/2014/main" id="{C8CDDCCD-7B76-AB0C-A3BE-0B85166C53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17473" y="2684859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75" name="Picture 74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9FF072AD-E603-AABA-0352-AFD43B5629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873" y="2684859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7FCE174E-A1D6-5D67-ED20-7992695A9EED}"/>
                </a:ext>
              </a:extLst>
            </p:cNvPr>
            <p:cNvGrpSpPr/>
            <p:nvPr/>
          </p:nvGrpSpPr>
          <p:grpSpPr>
            <a:xfrm>
              <a:off x="7214807" y="1982235"/>
              <a:ext cx="2311200" cy="1155600"/>
              <a:chOff x="783841" y="-1593354"/>
              <a:chExt cx="2311200" cy="1155600"/>
            </a:xfrm>
          </p:grpSpPr>
          <p:pic>
            <p:nvPicPr>
              <p:cNvPr id="77" name="Picture 76" descr="A close-up of a colorful circular object&#10;&#10;Description automatically generated">
                <a:extLst>
                  <a:ext uri="{FF2B5EF4-FFF2-40B4-BE49-F238E27FC236}">
                    <a16:creationId xmlns:a16="http://schemas.microsoft.com/office/drawing/2014/main" id="{218DE02D-A626-30F5-33BF-B4E1123DDC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39441" y="-1593354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79" name="Picture 78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E39308AC-59C5-624B-B1E3-3024B588A3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3841" y="-1593354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68B490C3-B2CE-77D1-B2BC-7560F367E3E4}"/>
                </a:ext>
              </a:extLst>
            </p:cNvPr>
            <p:cNvGrpSpPr/>
            <p:nvPr/>
          </p:nvGrpSpPr>
          <p:grpSpPr>
            <a:xfrm>
              <a:off x="7214807" y="3269763"/>
              <a:ext cx="2310673" cy="1155600"/>
              <a:chOff x="609600" y="1589451"/>
              <a:chExt cx="2310673" cy="1155600"/>
            </a:xfrm>
          </p:grpSpPr>
          <p:pic>
            <p:nvPicPr>
              <p:cNvPr id="83" name="Picture 82" descr="A close-up of a colorful circle&#10;&#10;Description automatically generated">
                <a:extLst>
                  <a:ext uri="{FF2B5EF4-FFF2-40B4-BE49-F238E27FC236}">
                    <a16:creationId xmlns:a16="http://schemas.microsoft.com/office/drawing/2014/main" id="{5EDCAB82-43B1-C05E-3654-86BF34EC01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64673" y="158945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85" name="Picture 8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34F3D0D7-D12A-E26C-3076-B7CAC881D8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9600" y="1589451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98993B3C-E2E1-D128-9552-8449B60326C2}"/>
                </a:ext>
              </a:extLst>
            </p:cNvPr>
            <p:cNvGrpSpPr/>
            <p:nvPr/>
          </p:nvGrpSpPr>
          <p:grpSpPr>
            <a:xfrm>
              <a:off x="4769097" y="3269763"/>
              <a:ext cx="2300151" cy="1155600"/>
              <a:chOff x="6057899" y="3303848"/>
              <a:chExt cx="2300151" cy="1155600"/>
            </a:xfrm>
          </p:grpSpPr>
          <p:pic>
            <p:nvPicPr>
              <p:cNvPr id="99" name="Picture 98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F42CB3D7-2F55-790C-5146-1300DECAFC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57899" y="3303848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01" name="Picture 100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747B91B7-EF5C-D6FC-1D18-E365CAB3F8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02450" y="3303848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95B0C435-CA49-5C69-5F9D-E9DB1A133754}"/>
                </a:ext>
              </a:extLst>
            </p:cNvPr>
            <p:cNvGrpSpPr/>
            <p:nvPr/>
          </p:nvGrpSpPr>
          <p:grpSpPr>
            <a:xfrm>
              <a:off x="2294157" y="3274828"/>
              <a:ext cx="2311200" cy="1155600"/>
              <a:chOff x="5753398" y="4672423"/>
              <a:chExt cx="2311200" cy="1155600"/>
            </a:xfrm>
          </p:grpSpPr>
          <p:pic>
            <p:nvPicPr>
              <p:cNvPr id="105" name="Picture 10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C71A8605-826F-8200-9ADA-91D00B95BB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53398" y="4672423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06" name="Picture 105" descr="A close-up of a brain&#10;&#10;Description automatically generated">
                <a:extLst>
                  <a:ext uri="{FF2B5EF4-FFF2-40B4-BE49-F238E27FC236}">
                    <a16:creationId xmlns:a16="http://schemas.microsoft.com/office/drawing/2014/main" id="{2D7E4B37-07EB-5EA9-ACF5-66BCBA3054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08998" y="4672423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C841638D-F4EE-D15D-BC15-27BFA3A9CB99}"/>
                </a:ext>
              </a:extLst>
            </p:cNvPr>
            <p:cNvGrpSpPr/>
            <p:nvPr/>
          </p:nvGrpSpPr>
          <p:grpSpPr>
            <a:xfrm>
              <a:off x="9672872" y="3269869"/>
              <a:ext cx="2310937" cy="1155600"/>
              <a:chOff x="4267200" y="1600200"/>
              <a:chExt cx="2310937" cy="1155600"/>
            </a:xfrm>
          </p:grpSpPr>
          <p:pic>
            <p:nvPicPr>
              <p:cNvPr id="108" name="Picture 107" descr="A close-up of a round object&#10;&#10;Description automatically generated">
                <a:extLst>
                  <a:ext uri="{FF2B5EF4-FFF2-40B4-BE49-F238E27FC236}">
                    <a16:creationId xmlns:a16="http://schemas.microsoft.com/office/drawing/2014/main" id="{68F79916-C4A5-102D-6B60-02647664E9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67200" y="1600200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10" name="Picture 109" descr="A close-up of a round object&#10;&#10;Description automatically generated">
                <a:extLst>
                  <a:ext uri="{FF2B5EF4-FFF2-40B4-BE49-F238E27FC236}">
                    <a16:creationId xmlns:a16="http://schemas.microsoft.com/office/drawing/2014/main" id="{007D1355-2383-A157-652E-95ED6EAB62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2537" y="1600200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34443BC2-BD92-B9AA-52BB-A6CD65975C73}"/>
                </a:ext>
              </a:extLst>
            </p:cNvPr>
            <p:cNvGrpSpPr/>
            <p:nvPr/>
          </p:nvGrpSpPr>
          <p:grpSpPr>
            <a:xfrm>
              <a:off x="4766378" y="4566901"/>
              <a:ext cx="2307828" cy="1155600"/>
              <a:chOff x="6353380" y="4526285"/>
              <a:chExt cx="2307828" cy="1155600"/>
            </a:xfrm>
          </p:grpSpPr>
          <p:pic>
            <p:nvPicPr>
              <p:cNvPr id="115" name="Picture 11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F78BA9FC-AAF3-AD20-6188-CCD038D674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53380" y="4526285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17" name="Picture 116" descr="A close-up of a brain scan&#10;&#10;Description automatically generated">
                <a:extLst>
                  <a:ext uri="{FF2B5EF4-FFF2-40B4-BE49-F238E27FC236}">
                    <a16:creationId xmlns:a16="http://schemas.microsoft.com/office/drawing/2014/main" id="{624DCF65-7B0E-CB2D-8123-425E1C67F2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05608" y="4526285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6A23D07F-15C9-DC5F-CF88-0E960D77ECA0}"/>
                </a:ext>
              </a:extLst>
            </p:cNvPr>
            <p:cNvGrpSpPr/>
            <p:nvPr/>
          </p:nvGrpSpPr>
          <p:grpSpPr>
            <a:xfrm>
              <a:off x="2294157" y="4567421"/>
              <a:ext cx="2307828" cy="1155600"/>
              <a:chOff x="-276893" y="308387"/>
              <a:chExt cx="2307828" cy="1155600"/>
            </a:xfrm>
          </p:grpSpPr>
          <p:pic>
            <p:nvPicPr>
              <p:cNvPr id="122" name="Picture 121" descr="A close-up of a infrared image of a human eye&#10;&#10;Description automatically generated">
                <a:extLst>
                  <a:ext uri="{FF2B5EF4-FFF2-40B4-BE49-F238E27FC236}">
                    <a16:creationId xmlns:a16="http://schemas.microsoft.com/office/drawing/2014/main" id="{4E58D2E7-5ADB-723D-4209-067CA89803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335" y="308387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23" name="Picture 122" descr="A close-up of a red circle&#10;&#10;Description automatically generated">
                <a:extLst>
                  <a:ext uri="{FF2B5EF4-FFF2-40B4-BE49-F238E27FC236}">
                    <a16:creationId xmlns:a16="http://schemas.microsoft.com/office/drawing/2014/main" id="{DC1D0271-B10C-2490-6D2D-0C9A8C4D31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76893" y="308387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A4BD5D1-BAC0-CDAB-5AF1-9C48EAD92308}"/>
                </a:ext>
              </a:extLst>
            </p:cNvPr>
            <p:cNvGrpSpPr/>
            <p:nvPr/>
          </p:nvGrpSpPr>
          <p:grpSpPr>
            <a:xfrm>
              <a:off x="7214807" y="4557291"/>
              <a:ext cx="2305107" cy="1155600"/>
              <a:chOff x="7214807" y="4557291"/>
              <a:chExt cx="2305107" cy="1155600"/>
            </a:xfrm>
          </p:grpSpPr>
          <p:pic>
            <p:nvPicPr>
              <p:cNvPr id="130" name="Picture 129" descr="A close-up of a red eyeball&#10;&#10;Description automatically generated">
                <a:extLst>
                  <a:ext uri="{FF2B5EF4-FFF2-40B4-BE49-F238E27FC236}">
                    <a16:creationId xmlns:a16="http://schemas.microsoft.com/office/drawing/2014/main" id="{3DE4850A-4954-3D05-43F4-E34B6A5F7B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4807" y="455729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32" name="Picture 131" descr="A close-up of a circular object&#10;&#10;Description automatically generated">
                <a:extLst>
                  <a:ext uri="{FF2B5EF4-FFF2-40B4-BE49-F238E27FC236}">
                    <a16:creationId xmlns:a16="http://schemas.microsoft.com/office/drawing/2014/main" id="{DB6CB7BF-F78E-5A8F-8670-F4D9D758F7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64314" y="4557291"/>
                <a:ext cx="1155600" cy="1155600"/>
              </a:xfrm>
              <a:prstGeom prst="rect">
                <a:avLst/>
              </a:prstGeom>
            </p:spPr>
          </p:pic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24F17079-FA64-683D-C648-BD27A85D5C98}"/>
                </a:ext>
              </a:extLst>
            </p:cNvPr>
            <p:cNvGrpSpPr/>
            <p:nvPr/>
          </p:nvGrpSpPr>
          <p:grpSpPr>
            <a:xfrm>
              <a:off x="9672609" y="4566901"/>
              <a:ext cx="2310937" cy="1155600"/>
              <a:chOff x="9672609" y="4566901"/>
              <a:chExt cx="2310937" cy="1155600"/>
            </a:xfrm>
          </p:grpSpPr>
          <p:pic>
            <p:nvPicPr>
              <p:cNvPr id="12" name="Picture 11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EE3080F1-4D4F-FE83-E05E-05E364C0C0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672609" y="4566901"/>
                <a:ext cx="1155600" cy="1155600"/>
              </a:xfrm>
              <a:prstGeom prst="rect">
                <a:avLst/>
              </a:prstGeom>
            </p:spPr>
          </p:pic>
          <p:pic>
            <p:nvPicPr>
              <p:cNvPr id="16" name="Picture 15" descr="A close-up of a planet&#10;&#10;Description automatically generated">
                <a:extLst>
                  <a:ext uri="{FF2B5EF4-FFF2-40B4-BE49-F238E27FC236}">
                    <a16:creationId xmlns:a16="http://schemas.microsoft.com/office/drawing/2014/main" id="{F0ABE767-A250-E983-D2F2-A9302BE35E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27946" y="4566901"/>
                <a:ext cx="1155600" cy="1155600"/>
              </a:xfrm>
              <a:prstGeom prst="rect">
                <a:avLst/>
              </a:prstGeom>
            </p:spPr>
          </p:pic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BA84F62-52A1-2586-4527-5FA97F5FABA1}"/>
              </a:ext>
            </a:extLst>
          </p:cNvPr>
          <p:cNvSpPr txBox="1"/>
          <p:nvPr/>
        </p:nvSpPr>
        <p:spPr>
          <a:xfrm>
            <a:off x="0" y="1057258"/>
            <a:ext cx="21112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ealthy</a:t>
            </a:r>
            <a:endParaRPr lang="en-GB" sz="160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A3B8CF9-3373-AD7A-1ABF-3E994D5AB854}"/>
              </a:ext>
            </a:extLst>
          </p:cNvPr>
          <p:cNvSpPr txBox="1"/>
          <p:nvPr/>
        </p:nvSpPr>
        <p:spPr>
          <a:xfrm>
            <a:off x="0" y="2384746"/>
            <a:ext cx="21112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e-Hypertension</a:t>
            </a:r>
            <a:endParaRPr lang="en-GB" sz="160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6D0FCE7-EA17-BA00-5895-7B5F93B84A44}"/>
              </a:ext>
            </a:extLst>
          </p:cNvPr>
          <p:cNvSpPr txBox="1"/>
          <p:nvPr/>
        </p:nvSpPr>
        <p:spPr>
          <a:xfrm>
            <a:off x="35452" y="3570298"/>
            <a:ext cx="207577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ell-Controlled </a:t>
            </a:r>
          </a:p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ypertension</a:t>
            </a:r>
            <a:endParaRPr lang="en-GB" sz="160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C30F3FB-7E78-3C51-E665-4FD52C22B2C6}"/>
              </a:ext>
            </a:extLst>
          </p:cNvPr>
          <p:cNvSpPr txBox="1"/>
          <p:nvPr/>
        </p:nvSpPr>
        <p:spPr>
          <a:xfrm>
            <a:off x="65107" y="4859598"/>
            <a:ext cx="20461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oorly Controlled </a:t>
            </a:r>
          </a:p>
          <a:p>
            <a:pPr algn="r"/>
            <a:r>
              <a:rPr lang="en-US" sz="1600" b="1" kern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ypertension</a:t>
            </a:r>
            <a:endParaRPr lang="en-GB" sz="1600"/>
          </a:p>
        </p:txBody>
      </p:sp>
    </p:spTree>
    <p:extLst>
      <p:ext uri="{BB962C8B-B14F-4D97-AF65-F5344CB8AC3E}">
        <p14:creationId xmlns:p14="http://schemas.microsoft.com/office/powerpoint/2010/main" val="2379826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dfc61bc-b031-4427-85ba-32f5acf44717" xsi:nil="true"/>
    <lcf76f155ced4ddcb4097134ff3c332f xmlns="ff7674ed-cd4e-4f63-aaba-a379a2a76354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6383F1755E2E48BAAFDD7FD7B69671" ma:contentTypeVersion="16" ma:contentTypeDescription="Create a new document." ma:contentTypeScope="" ma:versionID="de2cb1979a090741fb3d6508480bbae5">
  <xsd:schema xmlns:xsd="http://www.w3.org/2001/XMLSchema" xmlns:xs="http://www.w3.org/2001/XMLSchema" xmlns:p="http://schemas.microsoft.com/office/2006/metadata/properties" xmlns:ns2="ff7674ed-cd4e-4f63-aaba-a379a2a76354" xmlns:ns3="ddfc61bc-b031-4427-85ba-32f5acf44717" targetNamespace="http://schemas.microsoft.com/office/2006/metadata/properties" ma:root="true" ma:fieldsID="7556c5640c532f01b8be4a76e110c0bb" ns2:_="" ns3:_="">
    <xsd:import namespace="ff7674ed-cd4e-4f63-aaba-a379a2a76354"/>
    <xsd:import namespace="ddfc61bc-b031-4427-85ba-32f5acf4471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DateTake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f7674ed-cd4e-4f63-aaba-a379a2a7635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0cca7581-5256-458a-b218-643d9525617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2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dfc61bc-b031-4427-85ba-32f5acf44717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807fb3a9-ce3b-4def-aef9-830f709c61bd}" ma:internalName="TaxCatchAll" ma:showField="CatchAllData" ma:web="ddfc61bc-b031-4427-85ba-32f5acf4471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0980B7D-26E3-4797-8CEA-5315FA6EF74D}">
  <ds:schemaRefs>
    <ds:schemaRef ds:uri="http://purl.org/dc/dcmitype/"/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ddfc61bc-b031-4427-85ba-32f5acf44717"/>
    <ds:schemaRef ds:uri="http://schemas.microsoft.com/office/2006/metadata/properties"/>
    <ds:schemaRef ds:uri="ff7674ed-cd4e-4f63-aaba-a379a2a76354"/>
    <ds:schemaRef ds:uri="http://www.w3.org/XML/1998/namespace"/>
    <ds:schemaRef ds:uri="http://purl.org/dc/terms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85B15B33-9BC0-4761-9882-5C3F03760F1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879C532-1760-4E13-B12A-C6EA24C03B5D}">
  <ds:schemaRefs>
    <ds:schemaRef ds:uri="ddfc61bc-b031-4427-85ba-32f5acf44717"/>
    <ds:schemaRef ds:uri="ff7674ed-cd4e-4f63-aaba-a379a2a76354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Metadata/LabelInfo.xml><?xml version="1.0" encoding="utf-8"?>
<clbl:labelList xmlns:clbl="http://schemas.microsoft.com/office/2020/mipLabelMetadata">
  <clbl:label id="{5ba5ef5e-3109-4e77-85bd-cfeb0d347e82}" enabled="0" method="" siteId="{5ba5ef5e-3109-4e77-85bd-cfeb0d347e8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08</Words>
  <Application>Microsoft Office PowerPoint</Application>
  <PresentationFormat>Widescreen</PresentationFormat>
  <Paragraphs>3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thi Pushpanathan</dc:creator>
  <cp:lastModifiedBy>Parcon, Jennyca</cp:lastModifiedBy>
  <cp:revision>6</cp:revision>
  <dcterms:created xsi:type="dcterms:W3CDTF">2024-05-24T17:46:09Z</dcterms:created>
  <dcterms:modified xsi:type="dcterms:W3CDTF">2025-05-17T04:19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E6383F1755E2E48BAAFDD7FD7B69671</vt:lpwstr>
  </property>
  <property fmtid="{D5CDD505-2E9C-101B-9397-08002B2CF9AE}" pid="3" name="MediaServiceImageTags">
    <vt:lpwstr/>
  </property>
</Properties>
</file>